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8" r:id="rId3"/>
  </p:sldIdLst>
  <p:sldSz cx="10799763" cy="1526381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785" userDrawn="1">
          <p15:clr>
            <a:srgbClr val="A4A3A4"/>
          </p15:clr>
        </p15:guide>
        <p15:guide id="2" pos="419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A81FF"/>
    <a:srgbClr val="D883FF"/>
    <a:srgbClr val="F5B28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7207"/>
    <p:restoredTop sz="95118"/>
  </p:normalViewPr>
  <p:slideViewPr>
    <p:cSldViewPr snapToGrid="0" snapToObjects="1">
      <p:cViewPr varScale="1">
        <p:scale>
          <a:sx n="41" d="100"/>
          <a:sy n="41" d="100"/>
        </p:scale>
        <p:origin x="1632" y="208"/>
      </p:cViewPr>
      <p:guideLst>
        <p:guide orient="horz" pos="4785"/>
        <p:guide pos="419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09982" y="2498037"/>
            <a:ext cx="9179799" cy="5314068"/>
          </a:xfrm>
        </p:spPr>
        <p:txBody>
          <a:bodyPr anchor="b"/>
          <a:lstStyle>
            <a:lvl1pPr algn="ctr">
              <a:defRPr sz="708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49971" y="8017036"/>
            <a:ext cx="8099822" cy="3685220"/>
          </a:xfrm>
        </p:spPr>
        <p:txBody>
          <a:bodyPr/>
          <a:lstStyle>
            <a:lvl1pPr marL="0" indent="0" algn="ctr">
              <a:buNone/>
              <a:defRPr sz="2835"/>
            </a:lvl1pPr>
            <a:lvl2pPr marL="539999" indent="0" algn="ctr">
              <a:buNone/>
              <a:defRPr sz="2362"/>
            </a:lvl2pPr>
            <a:lvl3pPr marL="1079998" indent="0" algn="ctr">
              <a:buNone/>
              <a:defRPr sz="2126"/>
            </a:lvl3pPr>
            <a:lvl4pPr marL="1619997" indent="0" algn="ctr">
              <a:buNone/>
              <a:defRPr sz="1890"/>
            </a:lvl4pPr>
            <a:lvl5pPr marL="2159996" indent="0" algn="ctr">
              <a:buNone/>
              <a:defRPr sz="1890"/>
            </a:lvl5pPr>
            <a:lvl6pPr marL="2699995" indent="0" algn="ctr">
              <a:buNone/>
              <a:defRPr sz="1890"/>
            </a:lvl6pPr>
            <a:lvl7pPr marL="3239994" indent="0" algn="ctr">
              <a:buNone/>
              <a:defRPr sz="1890"/>
            </a:lvl7pPr>
            <a:lvl8pPr marL="3779992" indent="0" algn="ctr">
              <a:buNone/>
              <a:defRPr sz="1890"/>
            </a:lvl8pPr>
            <a:lvl9pPr marL="4319991" indent="0" algn="ctr">
              <a:buNone/>
              <a:defRPr sz="189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AB8F5-058D-6F42-9D33-9F26EFFF9B07}" type="datetimeFigureOut">
              <a:rPr kumimoji="1" lang="ja-JP" altLang="en-US" smtClean="0"/>
              <a:t>2023/3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DC1C6-D629-FF48-AF23-96BA6AD38F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21320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AB8F5-058D-6F42-9D33-9F26EFFF9B07}" type="datetimeFigureOut">
              <a:rPr kumimoji="1" lang="ja-JP" altLang="en-US" smtClean="0"/>
              <a:t>2023/3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DC1C6-D629-FF48-AF23-96BA6AD38F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63605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728581" y="812657"/>
            <a:ext cx="2328699" cy="12935376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42484" y="812657"/>
            <a:ext cx="6851100" cy="1293537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AB8F5-058D-6F42-9D33-9F26EFFF9B07}" type="datetimeFigureOut">
              <a:rPr kumimoji="1" lang="ja-JP" altLang="en-US" smtClean="0"/>
              <a:t>2023/3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DC1C6-D629-FF48-AF23-96BA6AD38F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74384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AB8F5-058D-6F42-9D33-9F26EFFF9B07}" type="datetimeFigureOut">
              <a:rPr kumimoji="1" lang="ja-JP" altLang="en-US" smtClean="0"/>
              <a:t>2023/3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DC1C6-D629-FF48-AF23-96BA6AD38F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24627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6859" y="3805358"/>
            <a:ext cx="9314796" cy="6349321"/>
          </a:xfrm>
        </p:spPr>
        <p:txBody>
          <a:bodyPr anchor="b"/>
          <a:lstStyle>
            <a:lvl1pPr>
              <a:defRPr sz="708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6859" y="10214746"/>
            <a:ext cx="9314796" cy="3338958"/>
          </a:xfrm>
        </p:spPr>
        <p:txBody>
          <a:bodyPr/>
          <a:lstStyle>
            <a:lvl1pPr marL="0" indent="0">
              <a:buNone/>
              <a:defRPr sz="2835">
                <a:solidFill>
                  <a:schemeClr val="tx1"/>
                </a:solidFill>
              </a:defRPr>
            </a:lvl1pPr>
            <a:lvl2pPr marL="539999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2pPr>
            <a:lvl3pPr marL="1079998" indent="0">
              <a:buNone/>
              <a:defRPr sz="2126">
                <a:solidFill>
                  <a:schemeClr val="tx1">
                    <a:tint val="75000"/>
                  </a:schemeClr>
                </a:solidFill>
              </a:defRPr>
            </a:lvl3pPr>
            <a:lvl4pPr marL="1619997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4pPr>
            <a:lvl5pPr marL="2159996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5pPr>
            <a:lvl6pPr marL="2699995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6pPr>
            <a:lvl7pPr marL="3239994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7pPr>
            <a:lvl8pPr marL="3779992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8pPr>
            <a:lvl9pPr marL="4319991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AB8F5-058D-6F42-9D33-9F26EFFF9B07}" type="datetimeFigureOut">
              <a:rPr kumimoji="1" lang="ja-JP" altLang="en-US" smtClean="0"/>
              <a:t>2023/3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DC1C6-D629-FF48-AF23-96BA6AD38F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7424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42484" y="4063284"/>
            <a:ext cx="4589899" cy="968474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67380" y="4063284"/>
            <a:ext cx="4589899" cy="968474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AB8F5-058D-6F42-9D33-9F26EFFF9B07}" type="datetimeFigureOut">
              <a:rPr kumimoji="1" lang="ja-JP" altLang="en-US" smtClean="0"/>
              <a:t>2023/3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DC1C6-D629-FF48-AF23-96BA6AD38F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11502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812660"/>
            <a:ext cx="9314796" cy="2950298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3892" y="3741755"/>
            <a:ext cx="4568805" cy="1833776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999" indent="0">
              <a:buNone/>
              <a:defRPr sz="2362" b="1"/>
            </a:lvl2pPr>
            <a:lvl3pPr marL="1079998" indent="0">
              <a:buNone/>
              <a:defRPr sz="2126" b="1"/>
            </a:lvl3pPr>
            <a:lvl4pPr marL="1619997" indent="0">
              <a:buNone/>
              <a:defRPr sz="1890" b="1"/>
            </a:lvl4pPr>
            <a:lvl5pPr marL="2159996" indent="0">
              <a:buNone/>
              <a:defRPr sz="1890" b="1"/>
            </a:lvl5pPr>
            <a:lvl6pPr marL="2699995" indent="0">
              <a:buNone/>
              <a:defRPr sz="1890" b="1"/>
            </a:lvl6pPr>
            <a:lvl7pPr marL="3239994" indent="0">
              <a:buNone/>
              <a:defRPr sz="1890" b="1"/>
            </a:lvl7pPr>
            <a:lvl8pPr marL="3779992" indent="0">
              <a:buNone/>
              <a:defRPr sz="1890" b="1"/>
            </a:lvl8pPr>
            <a:lvl9pPr marL="4319991" indent="0">
              <a:buNone/>
              <a:defRPr sz="189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43892" y="5575532"/>
            <a:ext cx="4568805" cy="820076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467381" y="3741755"/>
            <a:ext cx="4591306" cy="1833776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999" indent="0">
              <a:buNone/>
              <a:defRPr sz="2362" b="1"/>
            </a:lvl2pPr>
            <a:lvl3pPr marL="1079998" indent="0">
              <a:buNone/>
              <a:defRPr sz="2126" b="1"/>
            </a:lvl3pPr>
            <a:lvl4pPr marL="1619997" indent="0">
              <a:buNone/>
              <a:defRPr sz="1890" b="1"/>
            </a:lvl4pPr>
            <a:lvl5pPr marL="2159996" indent="0">
              <a:buNone/>
              <a:defRPr sz="1890" b="1"/>
            </a:lvl5pPr>
            <a:lvl6pPr marL="2699995" indent="0">
              <a:buNone/>
              <a:defRPr sz="1890" b="1"/>
            </a:lvl6pPr>
            <a:lvl7pPr marL="3239994" indent="0">
              <a:buNone/>
              <a:defRPr sz="1890" b="1"/>
            </a:lvl7pPr>
            <a:lvl8pPr marL="3779992" indent="0">
              <a:buNone/>
              <a:defRPr sz="1890" b="1"/>
            </a:lvl8pPr>
            <a:lvl9pPr marL="4319991" indent="0">
              <a:buNone/>
              <a:defRPr sz="189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467381" y="5575532"/>
            <a:ext cx="4591306" cy="820076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AB8F5-058D-6F42-9D33-9F26EFFF9B07}" type="datetimeFigureOut">
              <a:rPr kumimoji="1" lang="ja-JP" altLang="en-US" smtClean="0"/>
              <a:t>2023/3/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DC1C6-D629-FF48-AF23-96BA6AD38F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51074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AB8F5-058D-6F42-9D33-9F26EFFF9B07}" type="datetimeFigureOut">
              <a:rPr kumimoji="1" lang="ja-JP" altLang="en-US" smtClean="0"/>
              <a:t>2023/3/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DC1C6-D629-FF48-AF23-96BA6AD38F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70241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AB8F5-058D-6F42-9D33-9F26EFFF9B07}" type="datetimeFigureOut">
              <a:rPr kumimoji="1" lang="ja-JP" altLang="en-US" smtClean="0"/>
              <a:t>2023/3/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DC1C6-D629-FF48-AF23-96BA6AD38F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71589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1017588"/>
            <a:ext cx="3483205" cy="3561556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91306" y="2197710"/>
            <a:ext cx="5467380" cy="10847200"/>
          </a:xfrm>
        </p:spPr>
        <p:txBody>
          <a:bodyPr/>
          <a:lstStyle>
            <a:lvl1pPr>
              <a:defRPr sz="3780"/>
            </a:lvl1pPr>
            <a:lvl2pPr>
              <a:defRPr sz="3307"/>
            </a:lvl2pPr>
            <a:lvl3pPr>
              <a:defRPr sz="2835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4579144"/>
            <a:ext cx="3483205" cy="8483431"/>
          </a:xfrm>
        </p:spPr>
        <p:txBody>
          <a:bodyPr/>
          <a:lstStyle>
            <a:lvl1pPr marL="0" indent="0">
              <a:buNone/>
              <a:defRPr sz="1890"/>
            </a:lvl1pPr>
            <a:lvl2pPr marL="539999" indent="0">
              <a:buNone/>
              <a:defRPr sz="1654"/>
            </a:lvl2pPr>
            <a:lvl3pPr marL="1079998" indent="0">
              <a:buNone/>
              <a:defRPr sz="1417"/>
            </a:lvl3pPr>
            <a:lvl4pPr marL="1619997" indent="0">
              <a:buNone/>
              <a:defRPr sz="1181"/>
            </a:lvl4pPr>
            <a:lvl5pPr marL="2159996" indent="0">
              <a:buNone/>
              <a:defRPr sz="1181"/>
            </a:lvl5pPr>
            <a:lvl6pPr marL="2699995" indent="0">
              <a:buNone/>
              <a:defRPr sz="1181"/>
            </a:lvl6pPr>
            <a:lvl7pPr marL="3239994" indent="0">
              <a:buNone/>
              <a:defRPr sz="1181"/>
            </a:lvl7pPr>
            <a:lvl8pPr marL="3779992" indent="0">
              <a:buNone/>
              <a:defRPr sz="1181"/>
            </a:lvl8pPr>
            <a:lvl9pPr marL="4319991" indent="0">
              <a:buNone/>
              <a:defRPr sz="118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AB8F5-058D-6F42-9D33-9F26EFFF9B07}" type="datetimeFigureOut">
              <a:rPr kumimoji="1" lang="ja-JP" altLang="en-US" smtClean="0"/>
              <a:t>2023/3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DC1C6-D629-FF48-AF23-96BA6AD38F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79197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1017588"/>
            <a:ext cx="3483205" cy="3561556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591306" y="2197710"/>
            <a:ext cx="5467380" cy="10847200"/>
          </a:xfrm>
        </p:spPr>
        <p:txBody>
          <a:bodyPr anchor="t"/>
          <a:lstStyle>
            <a:lvl1pPr marL="0" indent="0">
              <a:buNone/>
              <a:defRPr sz="3780"/>
            </a:lvl1pPr>
            <a:lvl2pPr marL="539999" indent="0">
              <a:buNone/>
              <a:defRPr sz="3307"/>
            </a:lvl2pPr>
            <a:lvl3pPr marL="1079998" indent="0">
              <a:buNone/>
              <a:defRPr sz="2835"/>
            </a:lvl3pPr>
            <a:lvl4pPr marL="1619997" indent="0">
              <a:buNone/>
              <a:defRPr sz="2362"/>
            </a:lvl4pPr>
            <a:lvl5pPr marL="2159996" indent="0">
              <a:buNone/>
              <a:defRPr sz="2362"/>
            </a:lvl5pPr>
            <a:lvl6pPr marL="2699995" indent="0">
              <a:buNone/>
              <a:defRPr sz="2362"/>
            </a:lvl6pPr>
            <a:lvl7pPr marL="3239994" indent="0">
              <a:buNone/>
              <a:defRPr sz="2362"/>
            </a:lvl7pPr>
            <a:lvl8pPr marL="3779992" indent="0">
              <a:buNone/>
              <a:defRPr sz="2362"/>
            </a:lvl8pPr>
            <a:lvl9pPr marL="4319991" indent="0">
              <a:buNone/>
              <a:defRPr sz="2362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4579144"/>
            <a:ext cx="3483205" cy="8483431"/>
          </a:xfrm>
        </p:spPr>
        <p:txBody>
          <a:bodyPr/>
          <a:lstStyle>
            <a:lvl1pPr marL="0" indent="0">
              <a:buNone/>
              <a:defRPr sz="1890"/>
            </a:lvl1pPr>
            <a:lvl2pPr marL="539999" indent="0">
              <a:buNone/>
              <a:defRPr sz="1654"/>
            </a:lvl2pPr>
            <a:lvl3pPr marL="1079998" indent="0">
              <a:buNone/>
              <a:defRPr sz="1417"/>
            </a:lvl3pPr>
            <a:lvl4pPr marL="1619997" indent="0">
              <a:buNone/>
              <a:defRPr sz="1181"/>
            </a:lvl4pPr>
            <a:lvl5pPr marL="2159996" indent="0">
              <a:buNone/>
              <a:defRPr sz="1181"/>
            </a:lvl5pPr>
            <a:lvl6pPr marL="2699995" indent="0">
              <a:buNone/>
              <a:defRPr sz="1181"/>
            </a:lvl6pPr>
            <a:lvl7pPr marL="3239994" indent="0">
              <a:buNone/>
              <a:defRPr sz="1181"/>
            </a:lvl7pPr>
            <a:lvl8pPr marL="3779992" indent="0">
              <a:buNone/>
              <a:defRPr sz="1181"/>
            </a:lvl8pPr>
            <a:lvl9pPr marL="4319991" indent="0">
              <a:buNone/>
              <a:defRPr sz="118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AB8F5-058D-6F42-9D33-9F26EFFF9B07}" type="datetimeFigureOut">
              <a:rPr kumimoji="1" lang="ja-JP" altLang="en-US" smtClean="0"/>
              <a:t>2023/3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DC1C6-D629-FF48-AF23-96BA6AD38F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2242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42484" y="812660"/>
            <a:ext cx="9314796" cy="295029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2484" y="4063284"/>
            <a:ext cx="9314796" cy="968474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42484" y="14147297"/>
            <a:ext cx="2429947" cy="81265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8AB8F5-058D-6F42-9D33-9F26EFFF9B07}" type="datetimeFigureOut">
              <a:rPr kumimoji="1" lang="ja-JP" altLang="en-US" smtClean="0"/>
              <a:t>2023/3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577422" y="14147297"/>
            <a:ext cx="3644920" cy="81265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627332" y="14147297"/>
            <a:ext cx="2429947" cy="81265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CDC1C6-D629-FF48-AF23-96BA6AD38F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03518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79998" rtl="0" eaLnBrk="1" latinLnBrk="0" hangingPunct="1">
        <a:lnSpc>
          <a:spcPct val="90000"/>
        </a:lnSpc>
        <a:spcBef>
          <a:spcPct val="0"/>
        </a:spcBef>
        <a:buNone/>
        <a:defRPr kumimoji="1" sz="519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9999" indent="-269999" algn="l" defTabSz="1079998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kumimoji="1" sz="3307" kern="1200">
          <a:solidFill>
            <a:schemeClr val="tx1"/>
          </a:solidFill>
          <a:latin typeface="+mn-lt"/>
          <a:ea typeface="+mn-ea"/>
          <a:cs typeface="+mn-cs"/>
        </a:defRPr>
      </a:lvl1pPr>
      <a:lvl2pPr marL="809998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349997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889996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429995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969994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509993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4049992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589991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1pPr>
      <a:lvl2pPr marL="539999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2pPr>
      <a:lvl3pPr marL="1079998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3pPr>
      <a:lvl4pPr marL="1619997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159996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699995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239994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3779992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319991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764A25D-3A4F-F54A-88E8-EFAE079AF723}"/>
              </a:ext>
            </a:extLst>
          </p:cNvPr>
          <p:cNvSpPr txBox="1"/>
          <p:nvPr/>
        </p:nvSpPr>
        <p:spPr>
          <a:xfrm>
            <a:off x="4382125" y="2528799"/>
            <a:ext cx="15821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Meiryo UI" panose="020B0604030504040204" pitchFamily="34" charset="-128"/>
                <a:ea typeface="Meiryo UI" panose="020B0604030504040204" pitchFamily="34" charset="-128"/>
              </a:rPr>
              <a:t>Electron gun</a:t>
            </a:r>
            <a:endParaRPr kumimoji="1" lang="ja-JP" altLang="en-US" sz="1600">
              <a:latin typeface="Meiryo UI" panose="020B0604030504040204" pitchFamily="34" charset="-128"/>
              <a:ea typeface="Meiryo UI" panose="020B0604030504040204" pitchFamily="34" charset="-128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38135D7-9CE7-5D4C-A5C7-416292D265C4}"/>
              </a:ext>
            </a:extLst>
          </p:cNvPr>
          <p:cNvSpPr txBox="1"/>
          <p:nvPr/>
        </p:nvSpPr>
        <p:spPr>
          <a:xfrm>
            <a:off x="4315926" y="3355331"/>
            <a:ext cx="17145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Meiryo UI" panose="020B0604030504040204" pitchFamily="34" charset="-128"/>
                <a:ea typeface="Meiryo UI" panose="020B0604030504040204" pitchFamily="34" charset="-128"/>
              </a:rPr>
              <a:t>Condenser lens</a:t>
            </a:r>
            <a:endParaRPr kumimoji="1" lang="ja-JP" altLang="en-US" sz="1600">
              <a:latin typeface="Meiryo UI" panose="020B0604030504040204" pitchFamily="34" charset="-128"/>
              <a:ea typeface="Meiryo UI" panose="020B0604030504040204" pitchFamily="34" charset="-128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B382B59B-658D-C54F-B0DE-7BF2BB76B0E6}"/>
              </a:ext>
            </a:extLst>
          </p:cNvPr>
          <p:cNvSpPr txBox="1"/>
          <p:nvPr/>
        </p:nvSpPr>
        <p:spPr>
          <a:xfrm>
            <a:off x="1286970" y="7253348"/>
            <a:ext cx="10058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Meiryo UI" panose="020B0604030504040204" pitchFamily="34" charset="-128"/>
                <a:ea typeface="Meiryo UI" panose="020B0604030504040204" pitchFamily="34" charset="-128"/>
              </a:rPr>
              <a:t>Screen</a:t>
            </a:r>
            <a:endParaRPr kumimoji="1" lang="ja-JP" altLang="en-US" sz="1600">
              <a:latin typeface="Meiryo UI" panose="020B0604030504040204" pitchFamily="34" charset="-128"/>
              <a:ea typeface="Meiryo UI" panose="020B0604030504040204" pitchFamily="34" charset="-128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FC1AD8D-7D5A-5B4E-940D-45452F430A08}"/>
              </a:ext>
            </a:extLst>
          </p:cNvPr>
          <p:cNvSpPr txBox="1"/>
          <p:nvPr/>
        </p:nvSpPr>
        <p:spPr>
          <a:xfrm>
            <a:off x="4315927" y="5170915"/>
            <a:ext cx="17144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Meiryo UI" panose="020B0604030504040204" pitchFamily="34" charset="-128"/>
                <a:ea typeface="Meiryo UI" panose="020B0604030504040204" pitchFamily="34" charset="-128"/>
              </a:rPr>
              <a:t>Objective lens</a:t>
            </a:r>
            <a:endParaRPr kumimoji="1" lang="ja-JP" altLang="en-US" sz="1600">
              <a:latin typeface="Meiryo UI" panose="020B0604030504040204" pitchFamily="34" charset="-128"/>
              <a:ea typeface="Meiryo UI" panose="020B0604030504040204" pitchFamily="34" charset="-128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25B23969-1EA3-6843-BD7C-7AAE6A72652C}"/>
              </a:ext>
            </a:extLst>
          </p:cNvPr>
          <p:cNvSpPr txBox="1"/>
          <p:nvPr/>
        </p:nvSpPr>
        <p:spPr>
          <a:xfrm>
            <a:off x="4364987" y="6216641"/>
            <a:ext cx="16163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Meiryo UI" panose="020B0604030504040204" pitchFamily="34" charset="-128"/>
                <a:ea typeface="Meiryo UI" panose="020B0604030504040204" pitchFamily="34" charset="-128"/>
              </a:rPr>
              <a:t>Projector lens</a:t>
            </a:r>
            <a:endParaRPr kumimoji="1" lang="ja-JP" altLang="en-US" sz="1600">
              <a:latin typeface="Meiryo UI" panose="020B0604030504040204" pitchFamily="34" charset="-128"/>
              <a:ea typeface="Meiryo UI" panose="020B0604030504040204" pitchFamily="34" charset="-128"/>
            </a:endParaRPr>
          </a:p>
        </p:txBody>
      </p:sp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id="{DA8AA377-BA32-FF46-932F-4E4816904B84}"/>
              </a:ext>
            </a:extLst>
          </p:cNvPr>
          <p:cNvGrpSpPr/>
          <p:nvPr/>
        </p:nvGrpSpPr>
        <p:grpSpPr>
          <a:xfrm>
            <a:off x="2086245" y="2623811"/>
            <a:ext cx="2091689" cy="5091348"/>
            <a:chOff x="1687473" y="697230"/>
            <a:chExt cx="2091689" cy="5091348"/>
          </a:xfrm>
        </p:grpSpPr>
        <p:sp>
          <p:nvSpPr>
            <p:cNvPr id="11" name="台形 10">
              <a:extLst>
                <a:ext uri="{FF2B5EF4-FFF2-40B4-BE49-F238E27FC236}">
                  <a16:creationId xmlns:a16="http://schemas.microsoft.com/office/drawing/2014/main" id="{17A907F0-95B8-3342-90D3-04A05664794A}"/>
                </a:ext>
              </a:extLst>
            </p:cNvPr>
            <p:cNvSpPr/>
            <p:nvPr/>
          </p:nvSpPr>
          <p:spPr>
            <a:xfrm flipH="1">
              <a:off x="1687473" y="5239938"/>
              <a:ext cx="2091689" cy="548640"/>
            </a:xfrm>
            <a:prstGeom prst="trapezoid">
              <a:avLst>
                <a:gd name="adj" fmla="val 37500"/>
              </a:avLst>
            </a:prstGeom>
            <a:solidFill>
              <a:schemeClr val="bg1">
                <a:lumMod val="85000"/>
              </a:schemeClr>
            </a:solidFill>
            <a:ln w="1905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2" name="円柱 11">
              <a:extLst>
                <a:ext uri="{FF2B5EF4-FFF2-40B4-BE49-F238E27FC236}">
                  <a16:creationId xmlns:a16="http://schemas.microsoft.com/office/drawing/2014/main" id="{6953AFE6-FD4F-6F4F-943D-F21F002D78D5}"/>
                </a:ext>
              </a:extLst>
            </p:cNvPr>
            <p:cNvSpPr/>
            <p:nvPr/>
          </p:nvSpPr>
          <p:spPr>
            <a:xfrm>
              <a:off x="2521862" y="697230"/>
              <a:ext cx="422910" cy="274320"/>
            </a:xfrm>
            <a:prstGeom prst="can">
              <a:avLst/>
            </a:prstGeom>
            <a:solidFill>
              <a:schemeClr val="bg2">
                <a:lumMod val="50000"/>
              </a:schemeClr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" name="円柱 12">
              <a:extLst>
                <a:ext uri="{FF2B5EF4-FFF2-40B4-BE49-F238E27FC236}">
                  <a16:creationId xmlns:a16="http://schemas.microsoft.com/office/drawing/2014/main" id="{EDD087EA-5A31-DF4C-8BE5-CFEE61CE08A5}"/>
                </a:ext>
              </a:extLst>
            </p:cNvPr>
            <p:cNvSpPr/>
            <p:nvPr/>
          </p:nvSpPr>
          <p:spPr>
            <a:xfrm>
              <a:off x="1876067" y="1428750"/>
              <a:ext cx="1714500" cy="480060"/>
            </a:xfrm>
            <a:prstGeom prst="can">
              <a:avLst/>
            </a:prstGeom>
            <a:solidFill>
              <a:schemeClr val="bg2">
                <a:lumMod val="50000"/>
              </a:schemeClr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4" name="円/楕円 13">
              <a:extLst>
                <a:ext uri="{FF2B5EF4-FFF2-40B4-BE49-F238E27FC236}">
                  <a16:creationId xmlns:a16="http://schemas.microsoft.com/office/drawing/2014/main" id="{B6AE4450-34CE-BD4C-927E-153F5612C0C4}"/>
                </a:ext>
              </a:extLst>
            </p:cNvPr>
            <p:cNvSpPr/>
            <p:nvPr/>
          </p:nvSpPr>
          <p:spPr>
            <a:xfrm>
              <a:off x="2230397" y="1463040"/>
              <a:ext cx="1005840" cy="4572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5" name="グラフィックス 12" descr="花">
              <a:extLst>
                <a:ext uri="{FF2B5EF4-FFF2-40B4-BE49-F238E27FC236}">
                  <a16:creationId xmlns:a16="http://schemas.microsoft.com/office/drawing/2014/main" id="{EBFB62CE-6AFA-8640-AC2D-980E115CB397}"/>
                </a:ext>
              </a:extLst>
            </p:cNvPr>
            <p:cNvSpPr/>
            <p:nvPr/>
          </p:nvSpPr>
          <p:spPr>
            <a:xfrm rot="5400000">
              <a:off x="2533948" y="2137112"/>
              <a:ext cx="398739" cy="627935"/>
            </a:xfrm>
            <a:custGeom>
              <a:avLst/>
              <a:gdLst>
                <a:gd name="connsiteX0" fmla="*/ 722102 w 747355"/>
                <a:gd name="connsiteY0" fmla="*/ 161663 h 280511"/>
                <a:gd name="connsiteX1" fmla="*/ 414032 w 747355"/>
                <a:gd name="connsiteY1" fmla="*/ 232160 h 280511"/>
                <a:gd name="connsiteX2" fmla="*/ 412064 w 747355"/>
                <a:gd name="connsiteY2" fmla="*/ 233636 h 280511"/>
                <a:gd name="connsiteX3" fmla="*/ 412064 w 747355"/>
                <a:gd name="connsiteY3" fmla="*/ 158341 h 280511"/>
                <a:gd name="connsiteX4" fmla="*/ 557733 w 747355"/>
                <a:gd name="connsiteY4" fmla="*/ 3691 h 280511"/>
                <a:gd name="connsiteX5" fmla="*/ 524268 w 747355"/>
                <a:gd name="connsiteY5" fmla="*/ 3691 h 280511"/>
                <a:gd name="connsiteX6" fmla="*/ 457339 w 747355"/>
                <a:gd name="connsiteY6" fmla="*/ 46137 h 280511"/>
                <a:gd name="connsiteX7" fmla="*/ 390410 w 747355"/>
                <a:gd name="connsiteY7" fmla="*/ 3691 h 280511"/>
                <a:gd name="connsiteX8" fmla="*/ 373678 w 747355"/>
                <a:gd name="connsiteY8" fmla="*/ 0 h 280511"/>
                <a:gd name="connsiteX9" fmla="*/ 356946 w 747355"/>
                <a:gd name="connsiteY9" fmla="*/ 3691 h 280511"/>
                <a:gd name="connsiteX10" fmla="*/ 290017 w 747355"/>
                <a:gd name="connsiteY10" fmla="*/ 46137 h 280511"/>
                <a:gd name="connsiteX11" fmla="*/ 223088 w 747355"/>
                <a:gd name="connsiteY11" fmla="*/ 3691 h 280511"/>
                <a:gd name="connsiteX12" fmla="*/ 189623 w 747355"/>
                <a:gd name="connsiteY12" fmla="*/ 3691 h 280511"/>
                <a:gd name="connsiteX13" fmla="*/ 334308 w 747355"/>
                <a:gd name="connsiteY13" fmla="*/ 158341 h 280511"/>
                <a:gd name="connsiteX14" fmla="*/ 334308 w 747355"/>
                <a:gd name="connsiteY14" fmla="*/ 233267 h 280511"/>
                <a:gd name="connsiteX15" fmla="*/ 333324 w 747355"/>
                <a:gd name="connsiteY15" fmla="*/ 232529 h 280511"/>
                <a:gd name="connsiteX16" fmla="*/ 25253 w 747355"/>
                <a:gd name="connsiteY16" fmla="*/ 162032 h 280511"/>
                <a:gd name="connsiteX17" fmla="*/ 5568 w 747355"/>
                <a:gd name="connsiteY17" fmla="*/ 174212 h 280511"/>
                <a:gd name="connsiteX18" fmla="*/ 117773 w 747355"/>
                <a:gd name="connsiteY18" fmla="*/ 252829 h 280511"/>
                <a:gd name="connsiteX19" fmla="*/ 117773 w 747355"/>
                <a:gd name="connsiteY19" fmla="*/ 252829 h 280511"/>
                <a:gd name="connsiteX20" fmla="*/ 206355 w 747355"/>
                <a:gd name="connsiteY20" fmla="*/ 280511 h 280511"/>
                <a:gd name="connsiteX21" fmla="*/ 541000 w 747355"/>
                <a:gd name="connsiteY21" fmla="*/ 280511 h 280511"/>
                <a:gd name="connsiteX22" fmla="*/ 629583 w 747355"/>
                <a:gd name="connsiteY22" fmla="*/ 252829 h 280511"/>
                <a:gd name="connsiteX23" fmla="*/ 629583 w 747355"/>
                <a:gd name="connsiteY23" fmla="*/ 252829 h 280511"/>
                <a:gd name="connsiteX24" fmla="*/ 741787 w 747355"/>
                <a:gd name="connsiteY24" fmla="*/ 174212 h 280511"/>
                <a:gd name="connsiteX25" fmla="*/ 722102 w 747355"/>
                <a:gd name="connsiteY25" fmla="*/ 161663 h 28051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</a:cxnLst>
              <a:rect l="l" t="t" r="r" b="b"/>
              <a:pathLst>
                <a:path w="747355" h="280511">
                  <a:moveTo>
                    <a:pt x="722102" y="161663"/>
                  </a:moveTo>
                  <a:cubicBezTo>
                    <a:pt x="627614" y="171629"/>
                    <a:pt x="471119" y="193774"/>
                    <a:pt x="414032" y="232160"/>
                  </a:cubicBezTo>
                  <a:cubicBezTo>
                    <a:pt x="413048" y="232529"/>
                    <a:pt x="413048" y="233267"/>
                    <a:pt x="412064" y="233636"/>
                  </a:cubicBezTo>
                  <a:lnTo>
                    <a:pt x="412064" y="158341"/>
                  </a:lnTo>
                  <a:cubicBezTo>
                    <a:pt x="723087" y="147268"/>
                    <a:pt x="557733" y="3691"/>
                    <a:pt x="557733" y="3691"/>
                  </a:cubicBezTo>
                  <a:cubicBezTo>
                    <a:pt x="549859" y="-1107"/>
                    <a:pt x="531158" y="-1107"/>
                    <a:pt x="524268" y="3691"/>
                  </a:cubicBezTo>
                  <a:lnTo>
                    <a:pt x="457339" y="46137"/>
                  </a:lnTo>
                  <a:lnTo>
                    <a:pt x="390410" y="3691"/>
                  </a:lnTo>
                  <a:cubicBezTo>
                    <a:pt x="386473" y="1107"/>
                    <a:pt x="379583" y="0"/>
                    <a:pt x="373678" y="0"/>
                  </a:cubicBezTo>
                  <a:cubicBezTo>
                    <a:pt x="367772" y="0"/>
                    <a:pt x="360883" y="1107"/>
                    <a:pt x="356946" y="3691"/>
                  </a:cubicBezTo>
                  <a:lnTo>
                    <a:pt x="290017" y="46137"/>
                  </a:lnTo>
                  <a:lnTo>
                    <a:pt x="223088" y="3691"/>
                  </a:lnTo>
                  <a:cubicBezTo>
                    <a:pt x="215214" y="-1107"/>
                    <a:pt x="196513" y="-1107"/>
                    <a:pt x="189623" y="3691"/>
                  </a:cubicBezTo>
                  <a:cubicBezTo>
                    <a:pt x="189623" y="3691"/>
                    <a:pt x="24269" y="147268"/>
                    <a:pt x="334308" y="158341"/>
                  </a:cubicBezTo>
                  <a:lnTo>
                    <a:pt x="334308" y="233267"/>
                  </a:lnTo>
                  <a:cubicBezTo>
                    <a:pt x="334308" y="232898"/>
                    <a:pt x="333324" y="232898"/>
                    <a:pt x="333324" y="232529"/>
                  </a:cubicBezTo>
                  <a:cubicBezTo>
                    <a:pt x="276237" y="193774"/>
                    <a:pt x="120726" y="171998"/>
                    <a:pt x="25253" y="162032"/>
                  </a:cubicBezTo>
                  <a:cubicBezTo>
                    <a:pt x="5568" y="159818"/>
                    <a:pt x="-8211" y="168676"/>
                    <a:pt x="5568" y="174212"/>
                  </a:cubicBezTo>
                  <a:cubicBezTo>
                    <a:pt x="46907" y="190452"/>
                    <a:pt x="98088" y="217027"/>
                    <a:pt x="117773" y="252829"/>
                  </a:cubicBezTo>
                  <a:cubicBezTo>
                    <a:pt x="117773" y="252829"/>
                    <a:pt x="117773" y="252829"/>
                    <a:pt x="117773" y="252829"/>
                  </a:cubicBezTo>
                  <a:cubicBezTo>
                    <a:pt x="124663" y="268331"/>
                    <a:pt x="163048" y="280511"/>
                    <a:pt x="206355" y="280511"/>
                  </a:cubicBezTo>
                  <a:lnTo>
                    <a:pt x="541000" y="280511"/>
                  </a:lnTo>
                  <a:cubicBezTo>
                    <a:pt x="584307" y="280511"/>
                    <a:pt x="622693" y="268331"/>
                    <a:pt x="629583" y="252829"/>
                  </a:cubicBezTo>
                  <a:cubicBezTo>
                    <a:pt x="629583" y="252829"/>
                    <a:pt x="629583" y="252829"/>
                    <a:pt x="629583" y="252829"/>
                  </a:cubicBezTo>
                  <a:cubicBezTo>
                    <a:pt x="649268" y="217027"/>
                    <a:pt x="700449" y="190452"/>
                    <a:pt x="741787" y="174212"/>
                  </a:cubicBezTo>
                  <a:cubicBezTo>
                    <a:pt x="755567" y="168307"/>
                    <a:pt x="741787" y="159818"/>
                    <a:pt x="722102" y="161663"/>
                  </a:cubicBezTo>
                  <a:close/>
                </a:path>
              </a:pathLst>
            </a:custGeom>
            <a:solidFill>
              <a:srgbClr val="000000"/>
            </a:solidFill>
            <a:ln w="9823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6" name="台形 15">
              <a:extLst>
                <a:ext uri="{FF2B5EF4-FFF2-40B4-BE49-F238E27FC236}">
                  <a16:creationId xmlns:a16="http://schemas.microsoft.com/office/drawing/2014/main" id="{99A5C396-935A-164E-9FF2-7DFBDE36FB4A}"/>
                </a:ext>
              </a:extLst>
            </p:cNvPr>
            <p:cNvSpPr/>
            <p:nvPr/>
          </p:nvSpPr>
          <p:spPr>
            <a:xfrm>
              <a:off x="2230397" y="2160270"/>
              <a:ext cx="1005840" cy="548640"/>
            </a:xfrm>
            <a:prstGeom prst="trapezoid">
              <a:avLst>
                <a:gd name="adj" fmla="val 37500"/>
              </a:avLst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7" name="円柱 16">
              <a:extLst>
                <a:ext uri="{FF2B5EF4-FFF2-40B4-BE49-F238E27FC236}">
                  <a16:creationId xmlns:a16="http://schemas.microsoft.com/office/drawing/2014/main" id="{8A4267DA-ADC4-0541-8467-B5614A2A6316}"/>
                </a:ext>
              </a:extLst>
            </p:cNvPr>
            <p:cNvSpPr/>
            <p:nvPr/>
          </p:nvSpPr>
          <p:spPr>
            <a:xfrm>
              <a:off x="1876067" y="3188970"/>
              <a:ext cx="1714500" cy="480060"/>
            </a:xfrm>
            <a:prstGeom prst="can">
              <a:avLst/>
            </a:prstGeom>
            <a:solidFill>
              <a:schemeClr val="bg2">
                <a:lumMod val="50000"/>
              </a:schemeClr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8" name="円/楕円 17">
              <a:extLst>
                <a:ext uri="{FF2B5EF4-FFF2-40B4-BE49-F238E27FC236}">
                  <a16:creationId xmlns:a16="http://schemas.microsoft.com/office/drawing/2014/main" id="{14B5E733-3513-C244-BA61-330CD2A774E7}"/>
                </a:ext>
              </a:extLst>
            </p:cNvPr>
            <p:cNvSpPr/>
            <p:nvPr/>
          </p:nvSpPr>
          <p:spPr>
            <a:xfrm>
              <a:off x="2230397" y="3223260"/>
              <a:ext cx="1005840" cy="4572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9" name="台形 18">
              <a:extLst>
                <a:ext uri="{FF2B5EF4-FFF2-40B4-BE49-F238E27FC236}">
                  <a16:creationId xmlns:a16="http://schemas.microsoft.com/office/drawing/2014/main" id="{5D61FC55-62B1-7549-AC91-AC298AD41BC3}"/>
                </a:ext>
              </a:extLst>
            </p:cNvPr>
            <p:cNvSpPr/>
            <p:nvPr/>
          </p:nvSpPr>
          <p:spPr>
            <a:xfrm flipH="1">
              <a:off x="2230397" y="5024079"/>
              <a:ext cx="1005840" cy="548640"/>
            </a:xfrm>
            <a:prstGeom prst="trapezoid">
              <a:avLst>
                <a:gd name="adj" fmla="val 37500"/>
              </a:avLst>
            </a:prstGeom>
            <a:solidFill>
              <a:schemeClr val="bg1"/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0" name="円柱 19">
              <a:extLst>
                <a:ext uri="{FF2B5EF4-FFF2-40B4-BE49-F238E27FC236}">
                  <a16:creationId xmlns:a16="http://schemas.microsoft.com/office/drawing/2014/main" id="{037B70E3-5637-DA47-AC90-0779E2B3985E}"/>
                </a:ext>
              </a:extLst>
            </p:cNvPr>
            <p:cNvSpPr/>
            <p:nvPr/>
          </p:nvSpPr>
          <p:spPr>
            <a:xfrm>
              <a:off x="1876067" y="4290060"/>
              <a:ext cx="1714500" cy="480060"/>
            </a:xfrm>
            <a:prstGeom prst="can">
              <a:avLst/>
            </a:prstGeom>
            <a:solidFill>
              <a:schemeClr val="bg2">
                <a:lumMod val="50000"/>
              </a:schemeClr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1" name="円/楕円 20">
              <a:extLst>
                <a:ext uri="{FF2B5EF4-FFF2-40B4-BE49-F238E27FC236}">
                  <a16:creationId xmlns:a16="http://schemas.microsoft.com/office/drawing/2014/main" id="{92DF47F0-2460-8240-8F23-E528524E96E1}"/>
                </a:ext>
              </a:extLst>
            </p:cNvPr>
            <p:cNvSpPr/>
            <p:nvPr/>
          </p:nvSpPr>
          <p:spPr>
            <a:xfrm>
              <a:off x="2230397" y="4324350"/>
              <a:ext cx="1005840" cy="4572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2" name="グラフィックス 12" descr="花">
              <a:extLst>
                <a:ext uri="{FF2B5EF4-FFF2-40B4-BE49-F238E27FC236}">
                  <a16:creationId xmlns:a16="http://schemas.microsoft.com/office/drawing/2014/main" id="{192A9028-B9A6-B549-817A-258D21CB309C}"/>
                </a:ext>
              </a:extLst>
            </p:cNvPr>
            <p:cNvSpPr/>
            <p:nvPr/>
          </p:nvSpPr>
          <p:spPr>
            <a:xfrm rot="16200000" flipH="1">
              <a:off x="2533947" y="5000921"/>
              <a:ext cx="398739" cy="627935"/>
            </a:xfrm>
            <a:custGeom>
              <a:avLst/>
              <a:gdLst>
                <a:gd name="connsiteX0" fmla="*/ 722102 w 747355"/>
                <a:gd name="connsiteY0" fmla="*/ 161663 h 280511"/>
                <a:gd name="connsiteX1" fmla="*/ 414032 w 747355"/>
                <a:gd name="connsiteY1" fmla="*/ 232160 h 280511"/>
                <a:gd name="connsiteX2" fmla="*/ 412064 w 747355"/>
                <a:gd name="connsiteY2" fmla="*/ 233636 h 280511"/>
                <a:gd name="connsiteX3" fmla="*/ 412064 w 747355"/>
                <a:gd name="connsiteY3" fmla="*/ 158341 h 280511"/>
                <a:gd name="connsiteX4" fmla="*/ 557733 w 747355"/>
                <a:gd name="connsiteY4" fmla="*/ 3691 h 280511"/>
                <a:gd name="connsiteX5" fmla="*/ 524268 w 747355"/>
                <a:gd name="connsiteY5" fmla="*/ 3691 h 280511"/>
                <a:gd name="connsiteX6" fmla="*/ 457339 w 747355"/>
                <a:gd name="connsiteY6" fmla="*/ 46137 h 280511"/>
                <a:gd name="connsiteX7" fmla="*/ 390410 w 747355"/>
                <a:gd name="connsiteY7" fmla="*/ 3691 h 280511"/>
                <a:gd name="connsiteX8" fmla="*/ 373678 w 747355"/>
                <a:gd name="connsiteY8" fmla="*/ 0 h 280511"/>
                <a:gd name="connsiteX9" fmla="*/ 356946 w 747355"/>
                <a:gd name="connsiteY9" fmla="*/ 3691 h 280511"/>
                <a:gd name="connsiteX10" fmla="*/ 290017 w 747355"/>
                <a:gd name="connsiteY10" fmla="*/ 46137 h 280511"/>
                <a:gd name="connsiteX11" fmla="*/ 223088 w 747355"/>
                <a:gd name="connsiteY11" fmla="*/ 3691 h 280511"/>
                <a:gd name="connsiteX12" fmla="*/ 189623 w 747355"/>
                <a:gd name="connsiteY12" fmla="*/ 3691 h 280511"/>
                <a:gd name="connsiteX13" fmla="*/ 334308 w 747355"/>
                <a:gd name="connsiteY13" fmla="*/ 158341 h 280511"/>
                <a:gd name="connsiteX14" fmla="*/ 334308 w 747355"/>
                <a:gd name="connsiteY14" fmla="*/ 233267 h 280511"/>
                <a:gd name="connsiteX15" fmla="*/ 333324 w 747355"/>
                <a:gd name="connsiteY15" fmla="*/ 232529 h 280511"/>
                <a:gd name="connsiteX16" fmla="*/ 25253 w 747355"/>
                <a:gd name="connsiteY16" fmla="*/ 162032 h 280511"/>
                <a:gd name="connsiteX17" fmla="*/ 5568 w 747355"/>
                <a:gd name="connsiteY17" fmla="*/ 174212 h 280511"/>
                <a:gd name="connsiteX18" fmla="*/ 117773 w 747355"/>
                <a:gd name="connsiteY18" fmla="*/ 252829 h 280511"/>
                <a:gd name="connsiteX19" fmla="*/ 117773 w 747355"/>
                <a:gd name="connsiteY19" fmla="*/ 252829 h 280511"/>
                <a:gd name="connsiteX20" fmla="*/ 206355 w 747355"/>
                <a:gd name="connsiteY20" fmla="*/ 280511 h 280511"/>
                <a:gd name="connsiteX21" fmla="*/ 541000 w 747355"/>
                <a:gd name="connsiteY21" fmla="*/ 280511 h 280511"/>
                <a:gd name="connsiteX22" fmla="*/ 629583 w 747355"/>
                <a:gd name="connsiteY22" fmla="*/ 252829 h 280511"/>
                <a:gd name="connsiteX23" fmla="*/ 629583 w 747355"/>
                <a:gd name="connsiteY23" fmla="*/ 252829 h 280511"/>
                <a:gd name="connsiteX24" fmla="*/ 741787 w 747355"/>
                <a:gd name="connsiteY24" fmla="*/ 174212 h 280511"/>
                <a:gd name="connsiteX25" fmla="*/ 722102 w 747355"/>
                <a:gd name="connsiteY25" fmla="*/ 161663 h 28051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</a:cxnLst>
              <a:rect l="l" t="t" r="r" b="b"/>
              <a:pathLst>
                <a:path w="747355" h="280511">
                  <a:moveTo>
                    <a:pt x="722102" y="161663"/>
                  </a:moveTo>
                  <a:cubicBezTo>
                    <a:pt x="627614" y="171629"/>
                    <a:pt x="471119" y="193774"/>
                    <a:pt x="414032" y="232160"/>
                  </a:cubicBezTo>
                  <a:cubicBezTo>
                    <a:pt x="413048" y="232529"/>
                    <a:pt x="413048" y="233267"/>
                    <a:pt x="412064" y="233636"/>
                  </a:cubicBezTo>
                  <a:lnTo>
                    <a:pt x="412064" y="158341"/>
                  </a:lnTo>
                  <a:cubicBezTo>
                    <a:pt x="723087" y="147268"/>
                    <a:pt x="557733" y="3691"/>
                    <a:pt x="557733" y="3691"/>
                  </a:cubicBezTo>
                  <a:cubicBezTo>
                    <a:pt x="549859" y="-1107"/>
                    <a:pt x="531158" y="-1107"/>
                    <a:pt x="524268" y="3691"/>
                  </a:cubicBezTo>
                  <a:lnTo>
                    <a:pt x="457339" y="46137"/>
                  </a:lnTo>
                  <a:lnTo>
                    <a:pt x="390410" y="3691"/>
                  </a:lnTo>
                  <a:cubicBezTo>
                    <a:pt x="386473" y="1107"/>
                    <a:pt x="379583" y="0"/>
                    <a:pt x="373678" y="0"/>
                  </a:cubicBezTo>
                  <a:cubicBezTo>
                    <a:pt x="367772" y="0"/>
                    <a:pt x="360883" y="1107"/>
                    <a:pt x="356946" y="3691"/>
                  </a:cubicBezTo>
                  <a:lnTo>
                    <a:pt x="290017" y="46137"/>
                  </a:lnTo>
                  <a:lnTo>
                    <a:pt x="223088" y="3691"/>
                  </a:lnTo>
                  <a:cubicBezTo>
                    <a:pt x="215214" y="-1107"/>
                    <a:pt x="196513" y="-1107"/>
                    <a:pt x="189623" y="3691"/>
                  </a:cubicBezTo>
                  <a:cubicBezTo>
                    <a:pt x="189623" y="3691"/>
                    <a:pt x="24269" y="147268"/>
                    <a:pt x="334308" y="158341"/>
                  </a:cubicBezTo>
                  <a:lnTo>
                    <a:pt x="334308" y="233267"/>
                  </a:lnTo>
                  <a:cubicBezTo>
                    <a:pt x="334308" y="232898"/>
                    <a:pt x="333324" y="232898"/>
                    <a:pt x="333324" y="232529"/>
                  </a:cubicBezTo>
                  <a:cubicBezTo>
                    <a:pt x="276237" y="193774"/>
                    <a:pt x="120726" y="171998"/>
                    <a:pt x="25253" y="162032"/>
                  </a:cubicBezTo>
                  <a:cubicBezTo>
                    <a:pt x="5568" y="159818"/>
                    <a:pt x="-8211" y="168676"/>
                    <a:pt x="5568" y="174212"/>
                  </a:cubicBezTo>
                  <a:cubicBezTo>
                    <a:pt x="46907" y="190452"/>
                    <a:pt x="98088" y="217027"/>
                    <a:pt x="117773" y="252829"/>
                  </a:cubicBezTo>
                  <a:cubicBezTo>
                    <a:pt x="117773" y="252829"/>
                    <a:pt x="117773" y="252829"/>
                    <a:pt x="117773" y="252829"/>
                  </a:cubicBezTo>
                  <a:cubicBezTo>
                    <a:pt x="124663" y="268331"/>
                    <a:pt x="163048" y="280511"/>
                    <a:pt x="206355" y="280511"/>
                  </a:cubicBezTo>
                  <a:lnTo>
                    <a:pt x="541000" y="280511"/>
                  </a:lnTo>
                  <a:cubicBezTo>
                    <a:pt x="584307" y="280511"/>
                    <a:pt x="622693" y="268331"/>
                    <a:pt x="629583" y="252829"/>
                  </a:cubicBezTo>
                  <a:cubicBezTo>
                    <a:pt x="629583" y="252829"/>
                    <a:pt x="629583" y="252829"/>
                    <a:pt x="629583" y="252829"/>
                  </a:cubicBezTo>
                  <a:cubicBezTo>
                    <a:pt x="649268" y="217027"/>
                    <a:pt x="700449" y="190452"/>
                    <a:pt x="741787" y="174212"/>
                  </a:cubicBezTo>
                  <a:cubicBezTo>
                    <a:pt x="755567" y="168307"/>
                    <a:pt x="741787" y="159818"/>
                    <a:pt x="722102" y="161663"/>
                  </a:cubicBezTo>
                  <a:close/>
                </a:path>
              </a:pathLst>
            </a:custGeom>
            <a:solidFill>
              <a:srgbClr val="000000"/>
            </a:solidFill>
            <a:ln w="9823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</p:grp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1E2697AD-B295-054A-935D-D430113EF1D0}"/>
              </a:ext>
            </a:extLst>
          </p:cNvPr>
          <p:cNvSpPr txBox="1"/>
          <p:nvPr/>
        </p:nvSpPr>
        <p:spPr>
          <a:xfrm>
            <a:off x="1509386" y="4140785"/>
            <a:ext cx="27660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Meiryo UI" panose="020B0604030504040204" pitchFamily="34" charset="-128"/>
                <a:ea typeface="Meiryo UI" panose="020B0604030504040204" pitchFamily="34" charset="-128"/>
              </a:rPr>
              <a:t>Sample</a:t>
            </a:r>
            <a:endParaRPr kumimoji="1" lang="ja-JP" altLang="en-US" sz="1600">
              <a:latin typeface="Meiryo UI" panose="020B0604030504040204" pitchFamily="34" charset="-128"/>
              <a:ea typeface="Meiryo UI" panose="020B0604030504040204" pitchFamily="34" charset="-128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E18C248D-AB6F-404D-BD57-C19B06741D4A}"/>
              </a:ext>
            </a:extLst>
          </p:cNvPr>
          <p:cNvSpPr txBox="1"/>
          <p:nvPr/>
        </p:nvSpPr>
        <p:spPr>
          <a:xfrm>
            <a:off x="7693373" y="7284453"/>
            <a:ext cx="21814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Meiryo UI" panose="020B0604030504040204" pitchFamily="34" charset="-128"/>
                <a:ea typeface="Meiryo UI" panose="020B0604030504040204" pitchFamily="34" charset="-128"/>
              </a:rPr>
              <a:t>Sample</a:t>
            </a:r>
            <a:endParaRPr kumimoji="1" lang="ja-JP" altLang="en-US" sz="1600">
              <a:latin typeface="Meiryo UI" panose="020B0604030504040204" pitchFamily="34" charset="-128"/>
              <a:ea typeface="Meiryo UI" panose="020B0604030504040204" pitchFamily="34" charset="-128"/>
            </a:endParaRPr>
          </a:p>
        </p:txBody>
      </p:sp>
      <p:sp>
        <p:nvSpPr>
          <p:cNvPr id="25" name="円柱 24">
            <a:extLst>
              <a:ext uri="{FF2B5EF4-FFF2-40B4-BE49-F238E27FC236}">
                <a16:creationId xmlns:a16="http://schemas.microsoft.com/office/drawing/2014/main" id="{CE354A31-E370-854A-9240-42D8EC1F143E}"/>
              </a:ext>
            </a:extLst>
          </p:cNvPr>
          <p:cNvSpPr/>
          <p:nvPr/>
        </p:nvSpPr>
        <p:spPr>
          <a:xfrm rot="13860575">
            <a:off x="7767378" y="6312945"/>
            <a:ext cx="290439" cy="397615"/>
          </a:xfrm>
          <a:prstGeom prst="can">
            <a:avLst/>
          </a:prstGeom>
          <a:solidFill>
            <a:schemeClr val="bg2">
              <a:lumMod val="50000"/>
            </a:schemeClr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4F4DAF82-9703-F147-A170-92B6716DC25A}"/>
              </a:ext>
            </a:extLst>
          </p:cNvPr>
          <p:cNvSpPr txBox="1"/>
          <p:nvPr/>
        </p:nvSpPr>
        <p:spPr>
          <a:xfrm>
            <a:off x="7971504" y="6580557"/>
            <a:ext cx="194500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Meiryo UI" panose="020B0604030504040204" pitchFamily="34" charset="-128"/>
                <a:ea typeface="Meiryo UI" panose="020B0604030504040204" pitchFamily="34" charset="-128"/>
              </a:rPr>
              <a:t>Secondary</a:t>
            </a:r>
          </a:p>
          <a:p>
            <a:r>
              <a:rPr kumimoji="1" lang="en-US" altLang="ja-JP" sz="1600" dirty="0">
                <a:latin typeface="Meiryo UI" panose="020B0604030504040204" pitchFamily="34" charset="-128"/>
                <a:ea typeface="Meiryo UI" panose="020B0604030504040204" pitchFamily="34" charset="-128"/>
              </a:rPr>
              <a:t>electron detector</a:t>
            </a:r>
            <a:endParaRPr kumimoji="1" lang="ja-JP" altLang="en-US" sz="1600">
              <a:latin typeface="Meiryo UI" panose="020B0604030504040204" pitchFamily="34" charset="-128"/>
              <a:ea typeface="Meiryo UI" panose="020B0604030504040204" pitchFamily="34" charset="-128"/>
            </a:endParaRPr>
          </a:p>
        </p:txBody>
      </p:sp>
      <p:sp>
        <p:nvSpPr>
          <p:cNvPr id="27" name="円柱 26">
            <a:extLst>
              <a:ext uri="{FF2B5EF4-FFF2-40B4-BE49-F238E27FC236}">
                <a16:creationId xmlns:a16="http://schemas.microsoft.com/office/drawing/2014/main" id="{F702513D-938B-294A-A8F9-FCB1134BDC5F}"/>
              </a:ext>
            </a:extLst>
          </p:cNvPr>
          <p:cNvSpPr/>
          <p:nvPr/>
        </p:nvSpPr>
        <p:spPr>
          <a:xfrm>
            <a:off x="6835765" y="2623811"/>
            <a:ext cx="422910" cy="274320"/>
          </a:xfrm>
          <a:prstGeom prst="can">
            <a:avLst/>
          </a:prstGeom>
          <a:solidFill>
            <a:schemeClr val="bg2">
              <a:lumMod val="50000"/>
            </a:schemeClr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円柱 27">
            <a:extLst>
              <a:ext uri="{FF2B5EF4-FFF2-40B4-BE49-F238E27FC236}">
                <a16:creationId xmlns:a16="http://schemas.microsoft.com/office/drawing/2014/main" id="{E58D7625-3118-8F4B-805B-6349BC0CF770}"/>
              </a:ext>
            </a:extLst>
          </p:cNvPr>
          <p:cNvSpPr/>
          <p:nvPr/>
        </p:nvSpPr>
        <p:spPr>
          <a:xfrm>
            <a:off x="6189970" y="3355331"/>
            <a:ext cx="1714500" cy="480060"/>
          </a:xfrm>
          <a:prstGeom prst="can">
            <a:avLst/>
          </a:prstGeom>
          <a:solidFill>
            <a:schemeClr val="bg2">
              <a:lumMod val="50000"/>
            </a:schemeClr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" name="円/楕円 28">
            <a:extLst>
              <a:ext uri="{FF2B5EF4-FFF2-40B4-BE49-F238E27FC236}">
                <a16:creationId xmlns:a16="http://schemas.microsoft.com/office/drawing/2014/main" id="{ECC01E47-F141-9C47-8A69-921B36572981}"/>
              </a:ext>
            </a:extLst>
          </p:cNvPr>
          <p:cNvSpPr/>
          <p:nvPr/>
        </p:nvSpPr>
        <p:spPr>
          <a:xfrm>
            <a:off x="6546205" y="3389621"/>
            <a:ext cx="1005840" cy="45720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" name="円柱 29">
            <a:extLst>
              <a:ext uri="{FF2B5EF4-FFF2-40B4-BE49-F238E27FC236}">
                <a16:creationId xmlns:a16="http://schemas.microsoft.com/office/drawing/2014/main" id="{5F1A1E61-BBAA-5A47-A58E-78EA8E0E79CB}"/>
              </a:ext>
            </a:extLst>
          </p:cNvPr>
          <p:cNvSpPr/>
          <p:nvPr/>
        </p:nvSpPr>
        <p:spPr>
          <a:xfrm>
            <a:off x="6189970" y="5149841"/>
            <a:ext cx="1714500" cy="480060"/>
          </a:xfrm>
          <a:prstGeom prst="can">
            <a:avLst/>
          </a:prstGeom>
          <a:solidFill>
            <a:schemeClr val="bg2">
              <a:lumMod val="50000"/>
            </a:schemeClr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" name="円/楕円 30">
            <a:extLst>
              <a:ext uri="{FF2B5EF4-FFF2-40B4-BE49-F238E27FC236}">
                <a16:creationId xmlns:a16="http://schemas.microsoft.com/office/drawing/2014/main" id="{F99E5E5D-5BB8-D244-9B6C-6829F241C3D0}"/>
              </a:ext>
            </a:extLst>
          </p:cNvPr>
          <p:cNvSpPr/>
          <p:nvPr/>
        </p:nvSpPr>
        <p:spPr>
          <a:xfrm>
            <a:off x="6527157" y="5184131"/>
            <a:ext cx="1005840" cy="45720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" name="台形 31">
            <a:extLst>
              <a:ext uri="{FF2B5EF4-FFF2-40B4-BE49-F238E27FC236}">
                <a16:creationId xmlns:a16="http://schemas.microsoft.com/office/drawing/2014/main" id="{65079596-729A-104B-90AF-E20EECC97F91}"/>
              </a:ext>
            </a:extLst>
          </p:cNvPr>
          <p:cNvSpPr/>
          <p:nvPr/>
        </p:nvSpPr>
        <p:spPr>
          <a:xfrm>
            <a:off x="6544300" y="6873985"/>
            <a:ext cx="1005840" cy="548640"/>
          </a:xfrm>
          <a:prstGeom prst="trapezoid">
            <a:avLst>
              <a:gd name="adj" fmla="val 37500"/>
            </a:avLst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" name="円/楕円 32">
            <a:extLst>
              <a:ext uri="{FF2B5EF4-FFF2-40B4-BE49-F238E27FC236}">
                <a16:creationId xmlns:a16="http://schemas.microsoft.com/office/drawing/2014/main" id="{80E650B6-C2EB-9E40-9974-36D622481B8D}"/>
              </a:ext>
            </a:extLst>
          </p:cNvPr>
          <p:cNvSpPr/>
          <p:nvPr/>
        </p:nvSpPr>
        <p:spPr>
          <a:xfrm>
            <a:off x="6436490" y="6073261"/>
            <a:ext cx="1221460" cy="213839"/>
          </a:xfrm>
          <a:prstGeom prst="ellipse">
            <a:avLst/>
          </a:prstGeom>
          <a:solidFill>
            <a:schemeClr val="bg1">
              <a:lumMod val="65000"/>
            </a:schemeClr>
          </a:solidFill>
          <a:ln>
            <a:solidFill>
              <a:schemeClr val="bg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" name="円/楕円 33">
            <a:extLst>
              <a:ext uri="{FF2B5EF4-FFF2-40B4-BE49-F238E27FC236}">
                <a16:creationId xmlns:a16="http://schemas.microsoft.com/office/drawing/2014/main" id="{9ECF8B4C-F034-0A46-B359-0D29C69C552C}"/>
              </a:ext>
            </a:extLst>
          </p:cNvPr>
          <p:cNvSpPr/>
          <p:nvPr/>
        </p:nvSpPr>
        <p:spPr>
          <a:xfrm>
            <a:off x="6592595" y="6128624"/>
            <a:ext cx="909250" cy="88164"/>
          </a:xfrm>
          <a:prstGeom prst="ellips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5B347EB9-560D-8F4D-AAA9-C9BA7A52455A}"/>
              </a:ext>
            </a:extLst>
          </p:cNvPr>
          <p:cNvSpPr txBox="1"/>
          <p:nvPr/>
        </p:nvSpPr>
        <p:spPr>
          <a:xfrm>
            <a:off x="7583392" y="5660739"/>
            <a:ext cx="232463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Meiryo UI" panose="020B0604030504040204" pitchFamily="34" charset="-128"/>
                <a:ea typeface="Meiryo UI" panose="020B0604030504040204" pitchFamily="34" charset="-128"/>
              </a:rPr>
              <a:t>Back-scattered</a:t>
            </a:r>
          </a:p>
          <a:p>
            <a:r>
              <a:rPr kumimoji="1" lang="en-US" altLang="ja-JP" sz="1600" dirty="0">
                <a:latin typeface="Meiryo UI" panose="020B0604030504040204" pitchFamily="34" charset="-128"/>
                <a:ea typeface="Meiryo UI" panose="020B0604030504040204" pitchFamily="34" charset="-128"/>
              </a:rPr>
              <a:t>electron detector</a:t>
            </a:r>
            <a:endParaRPr kumimoji="1" lang="ja-JP" altLang="en-US" sz="1600">
              <a:latin typeface="Meiryo UI" panose="020B0604030504040204" pitchFamily="34" charset="-128"/>
              <a:ea typeface="Meiryo UI" panose="020B0604030504040204" pitchFamily="34" charset="-128"/>
            </a:endParaRPr>
          </a:p>
        </p:txBody>
      </p:sp>
      <p:sp>
        <p:nvSpPr>
          <p:cNvPr id="36" name="ドーナツ 35">
            <a:extLst>
              <a:ext uri="{FF2B5EF4-FFF2-40B4-BE49-F238E27FC236}">
                <a16:creationId xmlns:a16="http://schemas.microsoft.com/office/drawing/2014/main" id="{A83D51E1-4ABB-6948-B7E0-00F158849D12}"/>
              </a:ext>
            </a:extLst>
          </p:cNvPr>
          <p:cNvSpPr/>
          <p:nvPr/>
        </p:nvSpPr>
        <p:spPr>
          <a:xfrm>
            <a:off x="6632467" y="4287662"/>
            <a:ext cx="219763" cy="292134"/>
          </a:xfrm>
          <a:prstGeom prst="donut">
            <a:avLst>
              <a:gd name="adj" fmla="val 14799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37" name="ドーナツ 36">
            <a:extLst>
              <a:ext uri="{FF2B5EF4-FFF2-40B4-BE49-F238E27FC236}">
                <a16:creationId xmlns:a16="http://schemas.microsoft.com/office/drawing/2014/main" id="{9F69910E-F531-5B40-8705-F198159EFF1F}"/>
              </a:ext>
            </a:extLst>
          </p:cNvPr>
          <p:cNvSpPr/>
          <p:nvPr/>
        </p:nvSpPr>
        <p:spPr>
          <a:xfrm>
            <a:off x="6692677" y="4326801"/>
            <a:ext cx="181349" cy="301739"/>
          </a:xfrm>
          <a:prstGeom prst="donut">
            <a:avLst>
              <a:gd name="adj" fmla="val 21157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38" name="ドーナツ 37">
            <a:extLst>
              <a:ext uri="{FF2B5EF4-FFF2-40B4-BE49-F238E27FC236}">
                <a16:creationId xmlns:a16="http://schemas.microsoft.com/office/drawing/2014/main" id="{E9BD39C6-6135-BF4F-88F2-B456D3BBD6FB}"/>
              </a:ext>
            </a:extLst>
          </p:cNvPr>
          <p:cNvSpPr/>
          <p:nvPr/>
        </p:nvSpPr>
        <p:spPr>
          <a:xfrm>
            <a:off x="6679151" y="4248173"/>
            <a:ext cx="194875" cy="248041"/>
          </a:xfrm>
          <a:prstGeom prst="donut">
            <a:avLst>
              <a:gd name="adj" fmla="val 15433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39" name="ドーナツ 38">
            <a:extLst>
              <a:ext uri="{FF2B5EF4-FFF2-40B4-BE49-F238E27FC236}">
                <a16:creationId xmlns:a16="http://schemas.microsoft.com/office/drawing/2014/main" id="{90C0395C-1C84-F34B-8F8E-AEA36D9BE5CC}"/>
              </a:ext>
            </a:extLst>
          </p:cNvPr>
          <p:cNvSpPr/>
          <p:nvPr/>
        </p:nvSpPr>
        <p:spPr>
          <a:xfrm>
            <a:off x="6787127" y="4194223"/>
            <a:ext cx="147109" cy="248041"/>
          </a:xfrm>
          <a:prstGeom prst="donut">
            <a:avLst>
              <a:gd name="adj" fmla="val 25414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40" name="ドーナツ 39">
            <a:extLst>
              <a:ext uri="{FF2B5EF4-FFF2-40B4-BE49-F238E27FC236}">
                <a16:creationId xmlns:a16="http://schemas.microsoft.com/office/drawing/2014/main" id="{AF9D30BB-C587-0B43-88CD-81E9436D5A77}"/>
              </a:ext>
            </a:extLst>
          </p:cNvPr>
          <p:cNvSpPr/>
          <p:nvPr/>
        </p:nvSpPr>
        <p:spPr>
          <a:xfrm>
            <a:off x="6873124" y="4165945"/>
            <a:ext cx="125436" cy="248041"/>
          </a:xfrm>
          <a:prstGeom prst="donut">
            <a:avLst>
              <a:gd name="adj" fmla="val 25414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41" name="ドーナツ 40">
            <a:extLst>
              <a:ext uri="{FF2B5EF4-FFF2-40B4-BE49-F238E27FC236}">
                <a16:creationId xmlns:a16="http://schemas.microsoft.com/office/drawing/2014/main" id="{8217BC65-AA0B-E543-BA6B-8CB5C0E82A6E}"/>
              </a:ext>
            </a:extLst>
          </p:cNvPr>
          <p:cNvSpPr/>
          <p:nvPr/>
        </p:nvSpPr>
        <p:spPr>
          <a:xfrm>
            <a:off x="6979491" y="4143046"/>
            <a:ext cx="125436" cy="248041"/>
          </a:xfrm>
          <a:prstGeom prst="donut">
            <a:avLst>
              <a:gd name="adj" fmla="val 25414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42" name="ドーナツ 41">
            <a:extLst>
              <a:ext uri="{FF2B5EF4-FFF2-40B4-BE49-F238E27FC236}">
                <a16:creationId xmlns:a16="http://schemas.microsoft.com/office/drawing/2014/main" id="{F47A87AE-5543-7E45-AF72-A798EF14F9D5}"/>
              </a:ext>
            </a:extLst>
          </p:cNvPr>
          <p:cNvSpPr/>
          <p:nvPr/>
        </p:nvSpPr>
        <p:spPr>
          <a:xfrm flipH="1">
            <a:off x="7242214" y="4283468"/>
            <a:ext cx="219763" cy="292134"/>
          </a:xfrm>
          <a:prstGeom prst="donut">
            <a:avLst>
              <a:gd name="adj" fmla="val 14799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43" name="ドーナツ 42">
            <a:extLst>
              <a:ext uri="{FF2B5EF4-FFF2-40B4-BE49-F238E27FC236}">
                <a16:creationId xmlns:a16="http://schemas.microsoft.com/office/drawing/2014/main" id="{23A84262-4EC4-A847-BA58-F33FFECA569C}"/>
              </a:ext>
            </a:extLst>
          </p:cNvPr>
          <p:cNvSpPr/>
          <p:nvPr/>
        </p:nvSpPr>
        <p:spPr>
          <a:xfrm flipH="1">
            <a:off x="7220418" y="4322606"/>
            <a:ext cx="181349" cy="301739"/>
          </a:xfrm>
          <a:prstGeom prst="donut">
            <a:avLst>
              <a:gd name="adj" fmla="val 21157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44" name="ドーナツ 43">
            <a:extLst>
              <a:ext uri="{FF2B5EF4-FFF2-40B4-BE49-F238E27FC236}">
                <a16:creationId xmlns:a16="http://schemas.microsoft.com/office/drawing/2014/main" id="{43CB0874-F4EC-3840-BD8F-11120C734406}"/>
              </a:ext>
            </a:extLst>
          </p:cNvPr>
          <p:cNvSpPr/>
          <p:nvPr/>
        </p:nvSpPr>
        <p:spPr>
          <a:xfrm flipH="1">
            <a:off x="7155750" y="4369785"/>
            <a:ext cx="172929" cy="292134"/>
          </a:xfrm>
          <a:prstGeom prst="donut">
            <a:avLst>
              <a:gd name="adj" fmla="val 21157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45" name="ドーナツ 44">
            <a:extLst>
              <a:ext uri="{FF2B5EF4-FFF2-40B4-BE49-F238E27FC236}">
                <a16:creationId xmlns:a16="http://schemas.microsoft.com/office/drawing/2014/main" id="{3A9595F2-4A52-C745-8DC7-AFBAA89A4A99}"/>
              </a:ext>
            </a:extLst>
          </p:cNvPr>
          <p:cNvSpPr/>
          <p:nvPr/>
        </p:nvSpPr>
        <p:spPr>
          <a:xfrm flipH="1">
            <a:off x="7220418" y="4243978"/>
            <a:ext cx="194875" cy="248041"/>
          </a:xfrm>
          <a:prstGeom prst="donut">
            <a:avLst>
              <a:gd name="adj" fmla="val 15433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46" name="ドーナツ 45">
            <a:extLst>
              <a:ext uri="{FF2B5EF4-FFF2-40B4-BE49-F238E27FC236}">
                <a16:creationId xmlns:a16="http://schemas.microsoft.com/office/drawing/2014/main" id="{D08B63A7-94EA-5B4B-B7A5-C47833BF2EF4}"/>
              </a:ext>
            </a:extLst>
          </p:cNvPr>
          <p:cNvSpPr/>
          <p:nvPr/>
        </p:nvSpPr>
        <p:spPr>
          <a:xfrm flipH="1">
            <a:off x="7160208" y="4190029"/>
            <a:ext cx="147109" cy="248041"/>
          </a:xfrm>
          <a:prstGeom prst="donut">
            <a:avLst>
              <a:gd name="adj" fmla="val 25414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47" name="ドーナツ 46">
            <a:extLst>
              <a:ext uri="{FF2B5EF4-FFF2-40B4-BE49-F238E27FC236}">
                <a16:creationId xmlns:a16="http://schemas.microsoft.com/office/drawing/2014/main" id="{31E10B3C-4DCC-3549-B0B5-8EE0242BFE08}"/>
              </a:ext>
            </a:extLst>
          </p:cNvPr>
          <p:cNvSpPr/>
          <p:nvPr/>
        </p:nvSpPr>
        <p:spPr>
          <a:xfrm flipH="1">
            <a:off x="7095880" y="4161750"/>
            <a:ext cx="125436" cy="248041"/>
          </a:xfrm>
          <a:prstGeom prst="donut">
            <a:avLst>
              <a:gd name="adj" fmla="val 25414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F8E4D280-3084-BE46-9272-C5F63730EE2C}"/>
              </a:ext>
            </a:extLst>
          </p:cNvPr>
          <p:cNvSpPr txBox="1"/>
          <p:nvPr/>
        </p:nvSpPr>
        <p:spPr>
          <a:xfrm>
            <a:off x="7494747" y="4237048"/>
            <a:ext cx="17145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Meiryo UI" panose="020B0604030504040204" pitchFamily="34" charset="-128"/>
                <a:ea typeface="Meiryo UI" panose="020B0604030504040204" pitchFamily="34" charset="-128"/>
              </a:rPr>
              <a:t>Scanning coil</a:t>
            </a:r>
          </a:p>
        </p:txBody>
      </p:sp>
      <p:sp>
        <p:nvSpPr>
          <p:cNvPr id="49" name="下矢印 48">
            <a:extLst>
              <a:ext uri="{FF2B5EF4-FFF2-40B4-BE49-F238E27FC236}">
                <a16:creationId xmlns:a16="http://schemas.microsoft.com/office/drawing/2014/main" id="{07CF9B4D-54EA-024B-866B-74BCD1A62240}"/>
              </a:ext>
            </a:extLst>
          </p:cNvPr>
          <p:cNvSpPr/>
          <p:nvPr/>
        </p:nvSpPr>
        <p:spPr>
          <a:xfrm rot="14190908">
            <a:off x="7399469" y="6516441"/>
            <a:ext cx="160484" cy="670702"/>
          </a:xfrm>
          <a:prstGeom prst="downArrow">
            <a:avLst/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0" name="下矢印 49">
            <a:extLst>
              <a:ext uri="{FF2B5EF4-FFF2-40B4-BE49-F238E27FC236}">
                <a16:creationId xmlns:a16="http://schemas.microsoft.com/office/drawing/2014/main" id="{5CB32B0C-957D-5C49-8383-DE56F13C268D}"/>
              </a:ext>
            </a:extLst>
          </p:cNvPr>
          <p:cNvSpPr/>
          <p:nvPr/>
        </p:nvSpPr>
        <p:spPr>
          <a:xfrm rot="9459451">
            <a:off x="6671689" y="6315206"/>
            <a:ext cx="155179" cy="595530"/>
          </a:xfrm>
          <a:prstGeom prst="downArrow">
            <a:avLst/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9A36E9B4-55C8-4347-BAF7-976705621CDE}"/>
              </a:ext>
            </a:extLst>
          </p:cNvPr>
          <p:cNvSpPr txBox="1"/>
          <p:nvPr/>
        </p:nvSpPr>
        <p:spPr>
          <a:xfrm>
            <a:off x="1439481" y="2084797"/>
            <a:ext cx="226866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200" b="1" dirty="0">
                <a:latin typeface="Meiryo UI" panose="020B0604030504040204" pitchFamily="34" charset="-128"/>
                <a:ea typeface="Meiryo UI" panose="020B0604030504040204" pitchFamily="34" charset="-128"/>
              </a:rPr>
              <a:t>A            TEM</a:t>
            </a:r>
            <a:endParaRPr kumimoji="1" lang="ja-JP" altLang="en-US" sz="2200" b="1">
              <a:latin typeface="Meiryo UI" panose="020B0604030504040204" pitchFamily="34" charset="-128"/>
              <a:ea typeface="Meiryo UI" panose="020B0604030504040204" pitchFamily="34" charset="-128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BFA194C6-4C2E-5644-A595-B70D78765280}"/>
              </a:ext>
            </a:extLst>
          </p:cNvPr>
          <p:cNvSpPr txBox="1"/>
          <p:nvPr/>
        </p:nvSpPr>
        <p:spPr>
          <a:xfrm>
            <a:off x="5880570" y="2054753"/>
            <a:ext cx="178613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200" b="1" dirty="0">
                <a:latin typeface="Meiryo UI" panose="020B0604030504040204" pitchFamily="34" charset="-128"/>
                <a:ea typeface="Meiryo UI" panose="020B0604030504040204" pitchFamily="34" charset="-128"/>
              </a:rPr>
              <a:t>B      SEM</a:t>
            </a:r>
            <a:endParaRPr kumimoji="1" lang="ja-JP" altLang="en-US" sz="2200" b="1">
              <a:latin typeface="Meiryo UI" panose="020B0604030504040204" pitchFamily="34" charset="-128"/>
              <a:ea typeface="Meiryo UI" panose="020B0604030504040204" pitchFamily="34" charset="-128"/>
            </a:endParaRPr>
          </a:p>
        </p:txBody>
      </p:sp>
      <p:sp>
        <p:nvSpPr>
          <p:cNvPr id="53" name="三角形 52">
            <a:extLst>
              <a:ext uri="{FF2B5EF4-FFF2-40B4-BE49-F238E27FC236}">
                <a16:creationId xmlns:a16="http://schemas.microsoft.com/office/drawing/2014/main" id="{95A51232-D763-6940-A0D5-80A9C8D32BD6}"/>
              </a:ext>
            </a:extLst>
          </p:cNvPr>
          <p:cNvSpPr/>
          <p:nvPr/>
        </p:nvSpPr>
        <p:spPr>
          <a:xfrm>
            <a:off x="2785991" y="2907219"/>
            <a:ext cx="683486" cy="514823"/>
          </a:xfrm>
          <a:prstGeom prst="triangle">
            <a:avLst/>
          </a:prstGeom>
          <a:solidFill>
            <a:srgbClr val="BFBFBF">
              <a:alpha val="29804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4" name="台形 53">
            <a:extLst>
              <a:ext uri="{FF2B5EF4-FFF2-40B4-BE49-F238E27FC236}">
                <a16:creationId xmlns:a16="http://schemas.microsoft.com/office/drawing/2014/main" id="{BCB94A99-4E9F-2442-BA9F-AB2D86B009E6}"/>
              </a:ext>
            </a:extLst>
          </p:cNvPr>
          <p:cNvSpPr/>
          <p:nvPr/>
        </p:nvSpPr>
        <p:spPr>
          <a:xfrm rot="10800000">
            <a:off x="2500524" y="3807896"/>
            <a:ext cx="1207623" cy="1358371"/>
          </a:xfrm>
          <a:prstGeom prst="trapezoid">
            <a:avLst/>
          </a:prstGeom>
          <a:solidFill>
            <a:srgbClr val="BFBFBF">
              <a:alpha val="29804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5" name="台形 54">
            <a:extLst>
              <a:ext uri="{FF2B5EF4-FFF2-40B4-BE49-F238E27FC236}">
                <a16:creationId xmlns:a16="http://schemas.microsoft.com/office/drawing/2014/main" id="{827084C9-F836-A440-A6DE-FF000300FBBF}"/>
              </a:ext>
            </a:extLst>
          </p:cNvPr>
          <p:cNvSpPr/>
          <p:nvPr/>
        </p:nvSpPr>
        <p:spPr>
          <a:xfrm>
            <a:off x="2659350" y="5578069"/>
            <a:ext cx="880488" cy="695723"/>
          </a:xfrm>
          <a:prstGeom prst="trapezoid">
            <a:avLst/>
          </a:prstGeom>
          <a:solidFill>
            <a:srgbClr val="BFBFBF">
              <a:alpha val="29804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6" name="台形 55">
            <a:extLst>
              <a:ext uri="{FF2B5EF4-FFF2-40B4-BE49-F238E27FC236}">
                <a16:creationId xmlns:a16="http://schemas.microsoft.com/office/drawing/2014/main" id="{BBF73CB8-4817-C549-997D-F36852D16488}"/>
              </a:ext>
            </a:extLst>
          </p:cNvPr>
          <p:cNvSpPr/>
          <p:nvPr/>
        </p:nvSpPr>
        <p:spPr>
          <a:xfrm rot="10800000">
            <a:off x="2658452" y="6705184"/>
            <a:ext cx="880488" cy="695723"/>
          </a:xfrm>
          <a:prstGeom prst="trapezoid">
            <a:avLst/>
          </a:prstGeom>
          <a:solidFill>
            <a:srgbClr val="BFBFBF">
              <a:alpha val="29804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" name="三角形 56">
            <a:extLst>
              <a:ext uri="{FF2B5EF4-FFF2-40B4-BE49-F238E27FC236}">
                <a16:creationId xmlns:a16="http://schemas.microsoft.com/office/drawing/2014/main" id="{173E4469-A1E2-CC44-8A44-50BACC504E70}"/>
              </a:ext>
            </a:extLst>
          </p:cNvPr>
          <p:cNvSpPr/>
          <p:nvPr/>
        </p:nvSpPr>
        <p:spPr>
          <a:xfrm>
            <a:off x="6776109" y="2931815"/>
            <a:ext cx="536735" cy="514823"/>
          </a:xfrm>
          <a:prstGeom prst="triangle">
            <a:avLst/>
          </a:prstGeom>
          <a:solidFill>
            <a:srgbClr val="BFBFBF">
              <a:alpha val="29804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8" name="台形 57">
            <a:extLst>
              <a:ext uri="{FF2B5EF4-FFF2-40B4-BE49-F238E27FC236}">
                <a16:creationId xmlns:a16="http://schemas.microsoft.com/office/drawing/2014/main" id="{F8199620-BDD0-4D4B-9A22-6F3DA29A4E10}"/>
              </a:ext>
            </a:extLst>
          </p:cNvPr>
          <p:cNvSpPr/>
          <p:nvPr/>
        </p:nvSpPr>
        <p:spPr>
          <a:xfrm rot="10800000">
            <a:off x="6854415" y="3820884"/>
            <a:ext cx="353835" cy="1424625"/>
          </a:xfrm>
          <a:prstGeom prst="trapezoid">
            <a:avLst/>
          </a:prstGeom>
          <a:solidFill>
            <a:srgbClr val="BFBFBF">
              <a:alpha val="29804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9" name="台形 58">
            <a:extLst>
              <a:ext uri="{FF2B5EF4-FFF2-40B4-BE49-F238E27FC236}">
                <a16:creationId xmlns:a16="http://schemas.microsoft.com/office/drawing/2014/main" id="{30FED95C-ADF9-4E4B-9845-3CC84A3130E4}"/>
              </a:ext>
            </a:extLst>
          </p:cNvPr>
          <p:cNvSpPr/>
          <p:nvPr/>
        </p:nvSpPr>
        <p:spPr>
          <a:xfrm rot="10800000">
            <a:off x="6954253" y="5636357"/>
            <a:ext cx="147810" cy="1307994"/>
          </a:xfrm>
          <a:prstGeom prst="trapezoid">
            <a:avLst>
              <a:gd name="adj" fmla="val 45621"/>
            </a:avLst>
          </a:prstGeom>
          <a:solidFill>
            <a:srgbClr val="BFBFBF">
              <a:alpha val="29804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0" name="ドーナツ 59">
            <a:extLst>
              <a:ext uri="{FF2B5EF4-FFF2-40B4-BE49-F238E27FC236}">
                <a16:creationId xmlns:a16="http://schemas.microsoft.com/office/drawing/2014/main" id="{82049E4D-CF45-B741-A7C2-EE2C115CF94F}"/>
              </a:ext>
            </a:extLst>
          </p:cNvPr>
          <p:cNvSpPr/>
          <p:nvPr/>
        </p:nvSpPr>
        <p:spPr>
          <a:xfrm>
            <a:off x="6765765" y="4373980"/>
            <a:ext cx="172929" cy="292134"/>
          </a:xfrm>
          <a:prstGeom prst="donut">
            <a:avLst>
              <a:gd name="adj" fmla="val 21157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61" name="ドーナツ 60">
            <a:extLst>
              <a:ext uri="{FF2B5EF4-FFF2-40B4-BE49-F238E27FC236}">
                <a16:creationId xmlns:a16="http://schemas.microsoft.com/office/drawing/2014/main" id="{A9457F74-E1B8-1B4C-8C23-BBB55A209CC3}"/>
              </a:ext>
            </a:extLst>
          </p:cNvPr>
          <p:cNvSpPr/>
          <p:nvPr/>
        </p:nvSpPr>
        <p:spPr>
          <a:xfrm flipH="1">
            <a:off x="7069285" y="4409277"/>
            <a:ext cx="172929" cy="292134"/>
          </a:xfrm>
          <a:prstGeom prst="donut">
            <a:avLst>
              <a:gd name="adj" fmla="val 23080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62" name="ドーナツ 61">
            <a:extLst>
              <a:ext uri="{FF2B5EF4-FFF2-40B4-BE49-F238E27FC236}">
                <a16:creationId xmlns:a16="http://schemas.microsoft.com/office/drawing/2014/main" id="{74CFD042-381C-B54D-85A1-208A5C2F4589}"/>
              </a:ext>
            </a:extLst>
          </p:cNvPr>
          <p:cNvSpPr/>
          <p:nvPr/>
        </p:nvSpPr>
        <p:spPr>
          <a:xfrm>
            <a:off x="6992734" y="4415952"/>
            <a:ext cx="125436" cy="292134"/>
          </a:xfrm>
          <a:prstGeom prst="donut">
            <a:avLst>
              <a:gd name="adj" fmla="val 33918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63" name="ドーナツ 62">
            <a:extLst>
              <a:ext uri="{FF2B5EF4-FFF2-40B4-BE49-F238E27FC236}">
                <a16:creationId xmlns:a16="http://schemas.microsoft.com/office/drawing/2014/main" id="{BCD9A385-671D-FB4A-9763-979DE07BE342}"/>
              </a:ext>
            </a:extLst>
          </p:cNvPr>
          <p:cNvSpPr/>
          <p:nvPr/>
        </p:nvSpPr>
        <p:spPr>
          <a:xfrm>
            <a:off x="6852230" y="4413472"/>
            <a:ext cx="172929" cy="292134"/>
          </a:xfrm>
          <a:prstGeom prst="donut">
            <a:avLst>
              <a:gd name="adj" fmla="val 23080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64" name="グラフィックス 12" descr="花">
            <a:extLst>
              <a:ext uri="{FF2B5EF4-FFF2-40B4-BE49-F238E27FC236}">
                <a16:creationId xmlns:a16="http://schemas.microsoft.com/office/drawing/2014/main" id="{6911B91F-F71E-2140-9CCB-B31419119B23}"/>
              </a:ext>
            </a:extLst>
          </p:cNvPr>
          <p:cNvSpPr/>
          <p:nvPr/>
        </p:nvSpPr>
        <p:spPr>
          <a:xfrm>
            <a:off x="6751321" y="6693608"/>
            <a:ext cx="591798" cy="627935"/>
          </a:xfrm>
          <a:custGeom>
            <a:avLst/>
            <a:gdLst>
              <a:gd name="connsiteX0" fmla="*/ 722102 w 747355"/>
              <a:gd name="connsiteY0" fmla="*/ 161663 h 280511"/>
              <a:gd name="connsiteX1" fmla="*/ 414032 w 747355"/>
              <a:gd name="connsiteY1" fmla="*/ 232160 h 280511"/>
              <a:gd name="connsiteX2" fmla="*/ 412064 w 747355"/>
              <a:gd name="connsiteY2" fmla="*/ 233636 h 280511"/>
              <a:gd name="connsiteX3" fmla="*/ 412064 w 747355"/>
              <a:gd name="connsiteY3" fmla="*/ 158341 h 280511"/>
              <a:gd name="connsiteX4" fmla="*/ 557733 w 747355"/>
              <a:gd name="connsiteY4" fmla="*/ 3691 h 280511"/>
              <a:gd name="connsiteX5" fmla="*/ 524268 w 747355"/>
              <a:gd name="connsiteY5" fmla="*/ 3691 h 280511"/>
              <a:gd name="connsiteX6" fmla="*/ 457339 w 747355"/>
              <a:gd name="connsiteY6" fmla="*/ 46137 h 280511"/>
              <a:gd name="connsiteX7" fmla="*/ 390410 w 747355"/>
              <a:gd name="connsiteY7" fmla="*/ 3691 h 280511"/>
              <a:gd name="connsiteX8" fmla="*/ 373678 w 747355"/>
              <a:gd name="connsiteY8" fmla="*/ 0 h 280511"/>
              <a:gd name="connsiteX9" fmla="*/ 356946 w 747355"/>
              <a:gd name="connsiteY9" fmla="*/ 3691 h 280511"/>
              <a:gd name="connsiteX10" fmla="*/ 290017 w 747355"/>
              <a:gd name="connsiteY10" fmla="*/ 46137 h 280511"/>
              <a:gd name="connsiteX11" fmla="*/ 223088 w 747355"/>
              <a:gd name="connsiteY11" fmla="*/ 3691 h 280511"/>
              <a:gd name="connsiteX12" fmla="*/ 189623 w 747355"/>
              <a:gd name="connsiteY12" fmla="*/ 3691 h 280511"/>
              <a:gd name="connsiteX13" fmla="*/ 334308 w 747355"/>
              <a:gd name="connsiteY13" fmla="*/ 158341 h 280511"/>
              <a:gd name="connsiteX14" fmla="*/ 334308 w 747355"/>
              <a:gd name="connsiteY14" fmla="*/ 233267 h 280511"/>
              <a:gd name="connsiteX15" fmla="*/ 333324 w 747355"/>
              <a:gd name="connsiteY15" fmla="*/ 232529 h 280511"/>
              <a:gd name="connsiteX16" fmla="*/ 25253 w 747355"/>
              <a:gd name="connsiteY16" fmla="*/ 162032 h 280511"/>
              <a:gd name="connsiteX17" fmla="*/ 5568 w 747355"/>
              <a:gd name="connsiteY17" fmla="*/ 174212 h 280511"/>
              <a:gd name="connsiteX18" fmla="*/ 117773 w 747355"/>
              <a:gd name="connsiteY18" fmla="*/ 252829 h 280511"/>
              <a:gd name="connsiteX19" fmla="*/ 117773 w 747355"/>
              <a:gd name="connsiteY19" fmla="*/ 252829 h 280511"/>
              <a:gd name="connsiteX20" fmla="*/ 206355 w 747355"/>
              <a:gd name="connsiteY20" fmla="*/ 280511 h 280511"/>
              <a:gd name="connsiteX21" fmla="*/ 541000 w 747355"/>
              <a:gd name="connsiteY21" fmla="*/ 280511 h 280511"/>
              <a:gd name="connsiteX22" fmla="*/ 629583 w 747355"/>
              <a:gd name="connsiteY22" fmla="*/ 252829 h 280511"/>
              <a:gd name="connsiteX23" fmla="*/ 629583 w 747355"/>
              <a:gd name="connsiteY23" fmla="*/ 252829 h 280511"/>
              <a:gd name="connsiteX24" fmla="*/ 741787 w 747355"/>
              <a:gd name="connsiteY24" fmla="*/ 174212 h 280511"/>
              <a:gd name="connsiteX25" fmla="*/ 722102 w 747355"/>
              <a:gd name="connsiteY25" fmla="*/ 161663 h 28051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</a:cxnLst>
            <a:rect l="l" t="t" r="r" b="b"/>
            <a:pathLst>
              <a:path w="747355" h="280511">
                <a:moveTo>
                  <a:pt x="722102" y="161663"/>
                </a:moveTo>
                <a:cubicBezTo>
                  <a:pt x="627614" y="171629"/>
                  <a:pt x="471119" y="193774"/>
                  <a:pt x="414032" y="232160"/>
                </a:cubicBezTo>
                <a:cubicBezTo>
                  <a:pt x="413048" y="232529"/>
                  <a:pt x="413048" y="233267"/>
                  <a:pt x="412064" y="233636"/>
                </a:cubicBezTo>
                <a:lnTo>
                  <a:pt x="412064" y="158341"/>
                </a:lnTo>
                <a:cubicBezTo>
                  <a:pt x="723087" y="147268"/>
                  <a:pt x="557733" y="3691"/>
                  <a:pt x="557733" y="3691"/>
                </a:cubicBezTo>
                <a:cubicBezTo>
                  <a:pt x="549859" y="-1107"/>
                  <a:pt x="531158" y="-1107"/>
                  <a:pt x="524268" y="3691"/>
                </a:cubicBezTo>
                <a:lnTo>
                  <a:pt x="457339" y="46137"/>
                </a:lnTo>
                <a:lnTo>
                  <a:pt x="390410" y="3691"/>
                </a:lnTo>
                <a:cubicBezTo>
                  <a:pt x="386473" y="1107"/>
                  <a:pt x="379583" y="0"/>
                  <a:pt x="373678" y="0"/>
                </a:cubicBezTo>
                <a:cubicBezTo>
                  <a:pt x="367772" y="0"/>
                  <a:pt x="360883" y="1107"/>
                  <a:pt x="356946" y="3691"/>
                </a:cubicBezTo>
                <a:lnTo>
                  <a:pt x="290017" y="46137"/>
                </a:lnTo>
                <a:lnTo>
                  <a:pt x="223088" y="3691"/>
                </a:lnTo>
                <a:cubicBezTo>
                  <a:pt x="215214" y="-1107"/>
                  <a:pt x="196513" y="-1107"/>
                  <a:pt x="189623" y="3691"/>
                </a:cubicBezTo>
                <a:cubicBezTo>
                  <a:pt x="189623" y="3691"/>
                  <a:pt x="24269" y="147268"/>
                  <a:pt x="334308" y="158341"/>
                </a:cubicBezTo>
                <a:lnTo>
                  <a:pt x="334308" y="233267"/>
                </a:lnTo>
                <a:cubicBezTo>
                  <a:pt x="334308" y="232898"/>
                  <a:pt x="333324" y="232898"/>
                  <a:pt x="333324" y="232529"/>
                </a:cubicBezTo>
                <a:cubicBezTo>
                  <a:pt x="276237" y="193774"/>
                  <a:pt x="120726" y="171998"/>
                  <a:pt x="25253" y="162032"/>
                </a:cubicBezTo>
                <a:cubicBezTo>
                  <a:pt x="5568" y="159818"/>
                  <a:pt x="-8211" y="168676"/>
                  <a:pt x="5568" y="174212"/>
                </a:cubicBezTo>
                <a:cubicBezTo>
                  <a:pt x="46907" y="190452"/>
                  <a:pt x="98088" y="217027"/>
                  <a:pt x="117773" y="252829"/>
                </a:cubicBezTo>
                <a:cubicBezTo>
                  <a:pt x="117773" y="252829"/>
                  <a:pt x="117773" y="252829"/>
                  <a:pt x="117773" y="252829"/>
                </a:cubicBezTo>
                <a:cubicBezTo>
                  <a:pt x="124663" y="268331"/>
                  <a:pt x="163048" y="280511"/>
                  <a:pt x="206355" y="280511"/>
                </a:cubicBezTo>
                <a:lnTo>
                  <a:pt x="541000" y="280511"/>
                </a:lnTo>
                <a:cubicBezTo>
                  <a:pt x="584307" y="280511"/>
                  <a:pt x="622693" y="268331"/>
                  <a:pt x="629583" y="252829"/>
                </a:cubicBezTo>
                <a:cubicBezTo>
                  <a:pt x="629583" y="252829"/>
                  <a:pt x="629583" y="252829"/>
                  <a:pt x="629583" y="252829"/>
                </a:cubicBezTo>
                <a:cubicBezTo>
                  <a:pt x="649268" y="217027"/>
                  <a:pt x="700449" y="190452"/>
                  <a:pt x="741787" y="174212"/>
                </a:cubicBezTo>
                <a:cubicBezTo>
                  <a:pt x="755567" y="168307"/>
                  <a:pt x="741787" y="159818"/>
                  <a:pt x="722102" y="161663"/>
                </a:cubicBezTo>
                <a:close/>
              </a:path>
            </a:pathLst>
          </a:custGeom>
          <a:solidFill>
            <a:srgbClr val="000000"/>
          </a:solidFill>
          <a:ln w="9823" cap="flat">
            <a:noFill/>
            <a:prstDash val="solid"/>
            <a:miter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  <a:scene3d>
            <a:camera prst="isometricLeftDown"/>
            <a:lightRig rig="threePt" dir="t"/>
          </a:scene3d>
        </p:spPr>
        <p:txBody>
          <a:bodyPr rtlCol="0" anchor="ctr"/>
          <a:lstStyle/>
          <a:p>
            <a:endParaRPr lang="ja-JP" altLang="en-US"/>
          </a:p>
        </p:txBody>
      </p:sp>
      <p:sp>
        <p:nvSpPr>
          <p:cNvPr id="186" name="テキスト ボックス 185">
            <a:extLst>
              <a:ext uri="{FF2B5EF4-FFF2-40B4-BE49-F238E27FC236}">
                <a16:creationId xmlns:a16="http://schemas.microsoft.com/office/drawing/2014/main" id="{00E4EFB6-E18D-7546-B392-3CBBDDDCF3F1}"/>
              </a:ext>
            </a:extLst>
          </p:cNvPr>
          <p:cNvSpPr txBox="1"/>
          <p:nvPr/>
        </p:nvSpPr>
        <p:spPr>
          <a:xfrm>
            <a:off x="0" y="0"/>
            <a:ext cx="6672148" cy="8617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0" dirty="0"/>
              <a:t>Supplementary Figure S1</a:t>
            </a:r>
            <a:endParaRPr kumimoji="1" lang="ja-JP" altLang="en-US" sz="5000"/>
          </a:p>
        </p:txBody>
      </p:sp>
    </p:spTree>
    <p:extLst>
      <p:ext uri="{BB962C8B-B14F-4D97-AF65-F5344CB8AC3E}">
        <p14:creationId xmlns:p14="http://schemas.microsoft.com/office/powerpoint/2010/main" val="36205967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直方体 4">
            <a:extLst>
              <a:ext uri="{FF2B5EF4-FFF2-40B4-BE49-F238E27FC236}">
                <a16:creationId xmlns:a16="http://schemas.microsoft.com/office/drawing/2014/main" id="{EBF90987-510D-8F48-8137-9BDBEFF826DF}"/>
              </a:ext>
            </a:extLst>
          </p:cNvPr>
          <p:cNvSpPr/>
          <p:nvPr/>
        </p:nvSpPr>
        <p:spPr>
          <a:xfrm>
            <a:off x="7310496" y="4867451"/>
            <a:ext cx="926123" cy="820615"/>
          </a:xfrm>
          <a:prstGeom prst="cube">
            <a:avLst/>
          </a:prstGeom>
          <a:solidFill>
            <a:schemeClr val="bg1">
              <a:lumMod val="75000"/>
            </a:schemeClr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" name="グラフィックス 12" descr="花">
            <a:extLst>
              <a:ext uri="{FF2B5EF4-FFF2-40B4-BE49-F238E27FC236}">
                <a16:creationId xmlns:a16="http://schemas.microsoft.com/office/drawing/2014/main" id="{1C1DECE4-78AB-954B-B596-70E5520B4381}"/>
              </a:ext>
            </a:extLst>
          </p:cNvPr>
          <p:cNvSpPr/>
          <p:nvPr/>
        </p:nvSpPr>
        <p:spPr>
          <a:xfrm>
            <a:off x="7502195" y="5137850"/>
            <a:ext cx="398739" cy="483953"/>
          </a:xfrm>
          <a:custGeom>
            <a:avLst/>
            <a:gdLst>
              <a:gd name="connsiteX0" fmla="*/ 722102 w 747355"/>
              <a:gd name="connsiteY0" fmla="*/ 161663 h 280511"/>
              <a:gd name="connsiteX1" fmla="*/ 414032 w 747355"/>
              <a:gd name="connsiteY1" fmla="*/ 232160 h 280511"/>
              <a:gd name="connsiteX2" fmla="*/ 412064 w 747355"/>
              <a:gd name="connsiteY2" fmla="*/ 233636 h 280511"/>
              <a:gd name="connsiteX3" fmla="*/ 412064 w 747355"/>
              <a:gd name="connsiteY3" fmla="*/ 158341 h 280511"/>
              <a:gd name="connsiteX4" fmla="*/ 557733 w 747355"/>
              <a:gd name="connsiteY4" fmla="*/ 3691 h 280511"/>
              <a:gd name="connsiteX5" fmla="*/ 524268 w 747355"/>
              <a:gd name="connsiteY5" fmla="*/ 3691 h 280511"/>
              <a:gd name="connsiteX6" fmla="*/ 457339 w 747355"/>
              <a:gd name="connsiteY6" fmla="*/ 46137 h 280511"/>
              <a:gd name="connsiteX7" fmla="*/ 390410 w 747355"/>
              <a:gd name="connsiteY7" fmla="*/ 3691 h 280511"/>
              <a:gd name="connsiteX8" fmla="*/ 373678 w 747355"/>
              <a:gd name="connsiteY8" fmla="*/ 0 h 280511"/>
              <a:gd name="connsiteX9" fmla="*/ 356946 w 747355"/>
              <a:gd name="connsiteY9" fmla="*/ 3691 h 280511"/>
              <a:gd name="connsiteX10" fmla="*/ 290017 w 747355"/>
              <a:gd name="connsiteY10" fmla="*/ 46137 h 280511"/>
              <a:gd name="connsiteX11" fmla="*/ 223088 w 747355"/>
              <a:gd name="connsiteY11" fmla="*/ 3691 h 280511"/>
              <a:gd name="connsiteX12" fmla="*/ 189623 w 747355"/>
              <a:gd name="connsiteY12" fmla="*/ 3691 h 280511"/>
              <a:gd name="connsiteX13" fmla="*/ 334308 w 747355"/>
              <a:gd name="connsiteY13" fmla="*/ 158341 h 280511"/>
              <a:gd name="connsiteX14" fmla="*/ 334308 w 747355"/>
              <a:gd name="connsiteY14" fmla="*/ 233267 h 280511"/>
              <a:gd name="connsiteX15" fmla="*/ 333324 w 747355"/>
              <a:gd name="connsiteY15" fmla="*/ 232529 h 280511"/>
              <a:gd name="connsiteX16" fmla="*/ 25253 w 747355"/>
              <a:gd name="connsiteY16" fmla="*/ 162032 h 280511"/>
              <a:gd name="connsiteX17" fmla="*/ 5568 w 747355"/>
              <a:gd name="connsiteY17" fmla="*/ 174212 h 280511"/>
              <a:gd name="connsiteX18" fmla="*/ 117773 w 747355"/>
              <a:gd name="connsiteY18" fmla="*/ 252829 h 280511"/>
              <a:gd name="connsiteX19" fmla="*/ 117773 w 747355"/>
              <a:gd name="connsiteY19" fmla="*/ 252829 h 280511"/>
              <a:gd name="connsiteX20" fmla="*/ 206355 w 747355"/>
              <a:gd name="connsiteY20" fmla="*/ 280511 h 280511"/>
              <a:gd name="connsiteX21" fmla="*/ 541000 w 747355"/>
              <a:gd name="connsiteY21" fmla="*/ 280511 h 280511"/>
              <a:gd name="connsiteX22" fmla="*/ 629583 w 747355"/>
              <a:gd name="connsiteY22" fmla="*/ 252829 h 280511"/>
              <a:gd name="connsiteX23" fmla="*/ 629583 w 747355"/>
              <a:gd name="connsiteY23" fmla="*/ 252829 h 280511"/>
              <a:gd name="connsiteX24" fmla="*/ 741787 w 747355"/>
              <a:gd name="connsiteY24" fmla="*/ 174212 h 280511"/>
              <a:gd name="connsiteX25" fmla="*/ 722102 w 747355"/>
              <a:gd name="connsiteY25" fmla="*/ 161663 h 28051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</a:cxnLst>
            <a:rect l="l" t="t" r="r" b="b"/>
            <a:pathLst>
              <a:path w="747355" h="280511">
                <a:moveTo>
                  <a:pt x="722102" y="161663"/>
                </a:moveTo>
                <a:cubicBezTo>
                  <a:pt x="627614" y="171629"/>
                  <a:pt x="471119" y="193774"/>
                  <a:pt x="414032" y="232160"/>
                </a:cubicBezTo>
                <a:cubicBezTo>
                  <a:pt x="413048" y="232529"/>
                  <a:pt x="413048" y="233267"/>
                  <a:pt x="412064" y="233636"/>
                </a:cubicBezTo>
                <a:lnTo>
                  <a:pt x="412064" y="158341"/>
                </a:lnTo>
                <a:cubicBezTo>
                  <a:pt x="723087" y="147268"/>
                  <a:pt x="557733" y="3691"/>
                  <a:pt x="557733" y="3691"/>
                </a:cubicBezTo>
                <a:cubicBezTo>
                  <a:pt x="549859" y="-1107"/>
                  <a:pt x="531158" y="-1107"/>
                  <a:pt x="524268" y="3691"/>
                </a:cubicBezTo>
                <a:lnTo>
                  <a:pt x="457339" y="46137"/>
                </a:lnTo>
                <a:lnTo>
                  <a:pt x="390410" y="3691"/>
                </a:lnTo>
                <a:cubicBezTo>
                  <a:pt x="386473" y="1107"/>
                  <a:pt x="379583" y="0"/>
                  <a:pt x="373678" y="0"/>
                </a:cubicBezTo>
                <a:cubicBezTo>
                  <a:pt x="367772" y="0"/>
                  <a:pt x="360883" y="1107"/>
                  <a:pt x="356946" y="3691"/>
                </a:cubicBezTo>
                <a:lnTo>
                  <a:pt x="290017" y="46137"/>
                </a:lnTo>
                <a:lnTo>
                  <a:pt x="223088" y="3691"/>
                </a:lnTo>
                <a:cubicBezTo>
                  <a:pt x="215214" y="-1107"/>
                  <a:pt x="196513" y="-1107"/>
                  <a:pt x="189623" y="3691"/>
                </a:cubicBezTo>
                <a:cubicBezTo>
                  <a:pt x="189623" y="3691"/>
                  <a:pt x="24269" y="147268"/>
                  <a:pt x="334308" y="158341"/>
                </a:cubicBezTo>
                <a:lnTo>
                  <a:pt x="334308" y="233267"/>
                </a:lnTo>
                <a:cubicBezTo>
                  <a:pt x="334308" y="232898"/>
                  <a:pt x="333324" y="232898"/>
                  <a:pt x="333324" y="232529"/>
                </a:cubicBezTo>
                <a:cubicBezTo>
                  <a:pt x="276237" y="193774"/>
                  <a:pt x="120726" y="171998"/>
                  <a:pt x="25253" y="162032"/>
                </a:cubicBezTo>
                <a:cubicBezTo>
                  <a:pt x="5568" y="159818"/>
                  <a:pt x="-8211" y="168676"/>
                  <a:pt x="5568" y="174212"/>
                </a:cubicBezTo>
                <a:cubicBezTo>
                  <a:pt x="46907" y="190452"/>
                  <a:pt x="98088" y="217027"/>
                  <a:pt x="117773" y="252829"/>
                </a:cubicBezTo>
                <a:cubicBezTo>
                  <a:pt x="117773" y="252829"/>
                  <a:pt x="117773" y="252829"/>
                  <a:pt x="117773" y="252829"/>
                </a:cubicBezTo>
                <a:cubicBezTo>
                  <a:pt x="124663" y="268331"/>
                  <a:pt x="163048" y="280511"/>
                  <a:pt x="206355" y="280511"/>
                </a:cubicBezTo>
                <a:lnTo>
                  <a:pt x="541000" y="280511"/>
                </a:lnTo>
                <a:cubicBezTo>
                  <a:pt x="584307" y="280511"/>
                  <a:pt x="622693" y="268331"/>
                  <a:pt x="629583" y="252829"/>
                </a:cubicBezTo>
                <a:cubicBezTo>
                  <a:pt x="629583" y="252829"/>
                  <a:pt x="629583" y="252829"/>
                  <a:pt x="629583" y="252829"/>
                </a:cubicBezTo>
                <a:cubicBezTo>
                  <a:pt x="649268" y="217027"/>
                  <a:pt x="700449" y="190452"/>
                  <a:pt x="741787" y="174212"/>
                </a:cubicBezTo>
                <a:cubicBezTo>
                  <a:pt x="755567" y="168307"/>
                  <a:pt x="741787" y="159818"/>
                  <a:pt x="722102" y="161663"/>
                </a:cubicBezTo>
                <a:close/>
              </a:path>
            </a:pathLst>
          </a:custGeom>
          <a:solidFill>
            <a:srgbClr val="000000"/>
          </a:solidFill>
          <a:ln w="9823" cap="flat">
            <a:noFill/>
            <a:prstDash val="solid"/>
            <a:miter/>
          </a:ln>
        </p:spPr>
        <p:txBody>
          <a:bodyPr rtlCol="0" anchor="ctr"/>
          <a:lstStyle/>
          <a:p>
            <a:endParaRPr lang="ja-JP" altLang="en-US"/>
          </a:p>
        </p:txBody>
      </p:sp>
      <p:sp>
        <p:nvSpPr>
          <p:cNvPr id="7" name="直方体 6">
            <a:extLst>
              <a:ext uri="{FF2B5EF4-FFF2-40B4-BE49-F238E27FC236}">
                <a16:creationId xmlns:a16="http://schemas.microsoft.com/office/drawing/2014/main" id="{6C92D73C-28A6-2F40-B574-B4F64CCEB035}"/>
              </a:ext>
            </a:extLst>
          </p:cNvPr>
          <p:cNvSpPr/>
          <p:nvPr/>
        </p:nvSpPr>
        <p:spPr>
          <a:xfrm>
            <a:off x="4550962" y="5422505"/>
            <a:ext cx="926123" cy="820615"/>
          </a:xfrm>
          <a:prstGeom prst="cube">
            <a:avLst/>
          </a:prstGeom>
          <a:solidFill>
            <a:schemeClr val="bg1">
              <a:lumMod val="75000"/>
            </a:schemeClr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" name="グラフィックス 12" descr="花">
            <a:extLst>
              <a:ext uri="{FF2B5EF4-FFF2-40B4-BE49-F238E27FC236}">
                <a16:creationId xmlns:a16="http://schemas.microsoft.com/office/drawing/2014/main" id="{D09E39D0-A6F6-1545-9A53-1B95DF919903}"/>
              </a:ext>
            </a:extLst>
          </p:cNvPr>
          <p:cNvSpPr/>
          <p:nvPr/>
        </p:nvSpPr>
        <p:spPr>
          <a:xfrm rot="5400000">
            <a:off x="4748523" y="5687041"/>
            <a:ext cx="398739" cy="495676"/>
          </a:xfrm>
          <a:custGeom>
            <a:avLst/>
            <a:gdLst>
              <a:gd name="connsiteX0" fmla="*/ 722102 w 747355"/>
              <a:gd name="connsiteY0" fmla="*/ 161663 h 280511"/>
              <a:gd name="connsiteX1" fmla="*/ 414032 w 747355"/>
              <a:gd name="connsiteY1" fmla="*/ 232160 h 280511"/>
              <a:gd name="connsiteX2" fmla="*/ 412064 w 747355"/>
              <a:gd name="connsiteY2" fmla="*/ 233636 h 280511"/>
              <a:gd name="connsiteX3" fmla="*/ 412064 w 747355"/>
              <a:gd name="connsiteY3" fmla="*/ 158341 h 280511"/>
              <a:gd name="connsiteX4" fmla="*/ 557733 w 747355"/>
              <a:gd name="connsiteY4" fmla="*/ 3691 h 280511"/>
              <a:gd name="connsiteX5" fmla="*/ 524268 w 747355"/>
              <a:gd name="connsiteY5" fmla="*/ 3691 h 280511"/>
              <a:gd name="connsiteX6" fmla="*/ 457339 w 747355"/>
              <a:gd name="connsiteY6" fmla="*/ 46137 h 280511"/>
              <a:gd name="connsiteX7" fmla="*/ 390410 w 747355"/>
              <a:gd name="connsiteY7" fmla="*/ 3691 h 280511"/>
              <a:gd name="connsiteX8" fmla="*/ 373678 w 747355"/>
              <a:gd name="connsiteY8" fmla="*/ 0 h 280511"/>
              <a:gd name="connsiteX9" fmla="*/ 356946 w 747355"/>
              <a:gd name="connsiteY9" fmla="*/ 3691 h 280511"/>
              <a:gd name="connsiteX10" fmla="*/ 290017 w 747355"/>
              <a:gd name="connsiteY10" fmla="*/ 46137 h 280511"/>
              <a:gd name="connsiteX11" fmla="*/ 223088 w 747355"/>
              <a:gd name="connsiteY11" fmla="*/ 3691 h 280511"/>
              <a:gd name="connsiteX12" fmla="*/ 189623 w 747355"/>
              <a:gd name="connsiteY12" fmla="*/ 3691 h 280511"/>
              <a:gd name="connsiteX13" fmla="*/ 334308 w 747355"/>
              <a:gd name="connsiteY13" fmla="*/ 158341 h 280511"/>
              <a:gd name="connsiteX14" fmla="*/ 334308 w 747355"/>
              <a:gd name="connsiteY14" fmla="*/ 233267 h 280511"/>
              <a:gd name="connsiteX15" fmla="*/ 333324 w 747355"/>
              <a:gd name="connsiteY15" fmla="*/ 232529 h 280511"/>
              <a:gd name="connsiteX16" fmla="*/ 25253 w 747355"/>
              <a:gd name="connsiteY16" fmla="*/ 162032 h 280511"/>
              <a:gd name="connsiteX17" fmla="*/ 5568 w 747355"/>
              <a:gd name="connsiteY17" fmla="*/ 174212 h 280511"/>
              <a:gd name="connsiteX18" fmla="*/ 117773 w 747355"/>
              <a:gd name="connsiteY18" fmla="*/ 252829 h 280511"/>
              <a:gd name="connsiteX19" fmla="*/ 117773 w 747355"/>
              <a:gd name="connsiteY19" fmla="*/ 252829 h 280511"/>
              <a:gd name="connsiteX20" fmla="*/ 206355 w 747355"/>
              <a:gd name="connsiteY20" fmla="*/ 280511 h 280511"/>
              <a:gd name="connsiteX21" fmla="*/ 541000 w 747355"/>
              <a:gd name="connsiteY21" fmla="*/ 280511 h 280511"/>
              <a:gd name="connsiteX22" fmla="*/ 629583 w 747355"/>
              <a:gd name="connsiteY22" fmla="*/ 252829 h 280511"/>
              <a:gd name="connsiteX23" fmla="*/ 629583 w 747355"/>
              <a:gd name="connsiteY23" fmla="*/ 252829 h 280511"/>
              <a:gd name="connsiteX24" fmla="*/ 741787 w 747355"/>
              <a:gd name="connsiteY24" fmla="*/ 174212 h 280511"/>
              <a:gd name="connsiteX25" fmla="*/ 722102 w 747355"/>
              <a:gd name="connsiteY25" fmla="*/ 161663 h 28051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</a:cxnLst>
            <a:rect l="l" t="t" r="r" b="b"/>
            <a:pathLst>
              <a:path w="747355" h="280511">
                <a:moveTo>
                  <a:pt x="722102" y="161663"/>
                </a:moveTo>
                <a:cubicBezTo>
                  <a:pt x="627614" y="171629"/>
                  <a:pt x="471119" y="193774"/>
                  <a:pt x="414032" y="232160"/>
                </a:cubicBezTo>
                <a:cubicBezTo>
                  <a:pt x="413048" y="232529"/>
                  <a:pt x="413048" y="233267"/>
                  <a:pt x="412064" y="233636"/>
                </a:cubicBezTo>
                <a:lnTo>
                  <a:pt x="412064" y="158341"/>
                </a:lnTo>
                <a:cubicBezTo>
                  <a:pt x="723087" y="147268"/>
                  <a:pt x="557733" y="3691"/>
                  <a:pt x="557733" y="3691"/>
                </a:cubicBezTo>
                <a:cubicBezTo>
                  <a:pt x="549859" y="-1107"/>
                  <a:pt x="531158" y="-1107"/>
                  <a:pt x="524268" y="3691"/>
                </a:cubicBezTo>
                <a:lnTo>
                  <a:pt x="457339" y="46137"/>
                </a:lnTo>
                <a:lnTo>
                  <a:pt x="390410" y="3691"/>
                </a:lnTo>
                <a:cubicBezTo>
                  <a:pt x="386473" y="1107"/>
                  <a:pt x="379583" y="0"/>
                  <a:pt x="373678" y="0"/>
                </a:cubicBezTo>
                <a:cubicBezTo>
                  <a:pt x="367772" y="0"/>
                  <a:pt x="360883" y="1107"/>
                  <a:pt x="356946" y="3691"/>
                </a:cubicBezTo>
                <a:lnTo>
                  <a:pt x="290017" y="46137"/>
                </a:lnTo>
                <a:lnTo>
                  <a:pt x="223088" y="3691"/>
                </a:lnTo>
                <a:cubicBezTo>
                  <a:pt x="215214" y="-1107"/>
                  <a:pt x="196513" y="-1107"/>
                  <a:pt x="189623" y="3691"/>
                </a:cubicBezTo>
                <a:cubicBezTo>
                  <a:pt x="189623" y="3691"/>
                  <a:pt x="24269" y="147268"/>
                  <a:pt x="334308" y="158341"/>
                </a:cubicBezTo>
                <a:lnTo>
                  <a:pt x="334308" y="233267"/>
                </a:lnTo>
                <a:cubicBezTo>
                  <a:pt x="334308" y="232898"/>
                  <a:pt x="333324" y="232898"/>
                  <a:pt x="333324" y="232529"/>
                </a:cubicBezTo>
                <a:cubicBezTo>
                  <a:pt x="276237" y="193774"/>
                  <a:pt x="120726" y="171998"/>
                  <a:pt x="25253" y="162032"/>
                </a:cubicBezTo>
                <a:cubicBezTo>
                  <a:pt x="5568" y="159818"/>
                  <a:pt x="-8211" y="168676"/>
                  <a:pt x="5568" y="174212"/>
                </a:cubicBezTo>
                <a:cubicBezTo>
                  <a:pt x="46907" y="190452"/>
                  <a:pt x="98088" y="217027"/>
                  <a:pt x="117773" y="252829"/>
                </a:cubicBezTo>
                <a:cubicBezTo>
                  <a:pt x="117773" y="252829"/>
                  <a:pt x="117773" y="252829"/>
                  <a:pt x="117773" y="252829"/>
                </a:cubicBezTo>
                <a:cubicBezTo>
                  <a:pt x="124663" y="268331"/>
                  <a:pt x="163048" y="280511"/>
                  <a:pt x="206355" y="280511"/>
                </a:cubicBezTo>
                <a:lnTo>
                  <a:pt x="541000" y="280511"/>
                </a:lnTo>
                <a:cubicBezTo>
                  <a:pt x="584307" y="280511"/>
                  <a:pt x="622693" y="268331"/>
                  <a:pt x="629583" y="252829"/>
                </a:cubicBezTo>
                <a:cubicBezTo>
                  <a:pt x="629583" y="252829"/>
                  <a:pt x="629583" y="252829"/>
                  <a:pt x="629583" y="252829"/>
                </a:cubicBezTo>
                <a:cubicBezTo>
                  <a:pt x="649268" y="217027"/>
                  <a:pt x="700449" y="190452"/>
                  <a:pt x="741787" y="174212"/>
                </a:cubicBezTo>
                <a:cubicBezTo>
                  <a:pt x="755567" y="168307"/>
                  <a:pt x="741787" y="159818"/>
                  <a:pt x="722102" y="161663"/>
                </a:cubicBezTo>
                <a:close/>
              </a:path>
            </a:pathLst>
          </a:custGeom>
          <a:solidFill>
            <a:srgbClr val="000000"/>
          </a:solidFill>
          <a:ln w="9823" cap="flat">
            <a:noFill/>
            <a:prstDash val="solid"/>
            <a:miter/>
          </a:ln>
        </p:spPr>
        <p:txBody>
          <a:bodyPr rtlCol="0" anchor="ctr"/>
          <a:lstStyle/>
          <a:p>
            <a:endParaRPr lang="ja-JP" altLang="en-US"/>
          </a:p>
        </p:txBody>
      </p:sp>
      <p:sp>
        <p:nvSpPr>
          <p:cNvPr id="9" name="直方体 8">
            <a:extLst>
              <a:ext uri="{FF2B5EF4-FFF2-40B4-BE49-F238E27FC236}">
                <a16:creationId xmlns:a16="http://schemas.microsoft.com/office/drawing/2014/main" id="{D4C8A7A0-7502-D54E-B349-CFA58F77B809}"/>
              </a:ext>
            </a:extLst>
          </p:cNvPr>
          <p:cNvSpPr/>
          <p:nvPr/>
        </p:nvSpPr>
        <p:spPr>
          <a:xfrm>
            <a:off x="1640406" y="5384764"/>
            <a:ext cx="926123" cy="820615"/>
          </a:xfrm>
          <a:prstGeom prst="cube">
            <a:avLst/>
          </a:prstGeom>
          <a:solidFill>
            <a:schemeClr val="bg1">
              <a:lumMod val="75000"/>
            </a:schemeClr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" name="グラフィックス 12" descr="花">
            <a:extLst>
              <a:ext uri="{FF2B5EF4-FFF2-40B4-BE49-F238E27FC236}">
                <a16:creationId xmlns:a16="http://schemas.microsoft.com/office/drawing/2014/main" id="{F494C7CB-BFB5-984B-BECB-55B23AF9B546}"/>
              </a:ext>
            </a:extLst>
          </p:cNvPr>
          <p:cNvSpPr/>
          <p:nvPr/>
        </p:nvSpPr>
        <p:spPr>
          <a:xfrm rot="5400000">
            <a:off x="1851343" y="5635925"/>
            <a:ext cx="398739" cy="522429"/>
          </a:xfrm>
          <a:custGeom>
            <a:avLst/>
            <a:gdLst>
              <a:gd name="connsiteX0" fmla="*/ 722102 w 747355"/>
              <a:gd name="connsiteY0" fmla="*/ 161663 h 280511"/>
              <a:gd name="connsiteX1" fmla="*/ 414032 w 747355"/>
              <a:gd name="connsiteY1" fmla="*/ 232160 h 280511"/>
              <a:gd name="connsiteX2" fmla="*/ 412064 w 747355"/>
              <a:gd name="connsiteY2" fmla="*/ 233636 h 280511"/>
              <a:gd name="connsiteX3" fmla="*/ 412064 w 747355"/>
              <a:gd name="connsiteY3" fmla="*/ 158341 h 280511"/>
              <a:gd name="connsiteX4" fmla="*/ 557733 w 747355"/>
              <a:gd name="connsiteY4" fmla="*/ 3691 h 280511"/>
              <a:gd name="connsiteX5" fmla="*/ 524268 w 747355"/>
              <a:gd name="connsiteY5" fmla="*/ 3691 h 280511"/>
              <a:gd name="connsiteX6" fmla="*/ 457339 w 747355"/>
              <a:gd name="connsiteY6" fmla="*/ 46137 h 280511"/>
              <a:gd name="connsiteX7" fmla="*/ 390410 w 747355"/>
              <a:gd name="connsiteY7" fmla="*/ 3691 h 280511"/>
              <a:gd name="connsiteX8" fmla="*/ 373678 w 747355"/>
              <a:gd name="connsiteY8" fmla="*/ 0 h 280511"/>
              <a:gd name="connsiteX9" fmla="*/ 356946 w 747355"/>
              <a:gd name="connsiteY9" fmla="*/ 3691 h 280511"/>
              <a:gd name="connsiteX10" fmla="*/ 290017 w 747355"/>
              <a:gd name="connsiteY10" fmla="*/ 46137 h 280511"/>
              <a:gd name="connsiteX11" fmla="*/ 223088 w 747355"/>
              <a:gd name="connsiteY11" fmla="*/ 3691 h 280511"/>
              <a:gd name="connsiteX12" fmla="*/ 189623 w 747355"/>
              <a:gd name="connsiteY12" fmla="*/ 3691 h 280511"/>
              <a:gd name="connsiteX13" fmla="*/ 334308 w 747355"/>
              <a:gd name="connsiteY13" fmla="*/ 158341 h 280511"/>
              <a:gd name="connsiteX14" fmla="*/ 334308 w 747355"/>
              <a:gd name="connsiteY14" fmla="*/ 233267 h 280511"/>
              <a:gd name="connsiteX15" fmla="*/ 333324 w 747355"/>
              <a:gd name="connsiteY15" fmla="*/ 232529 h 280511"/>
              <a:gd name="connsiteX16" fmla="*/ 25253 w 747355"/>
              <a:gd name="connsiteY16" fmla="*/ 162032 h 280511"/>
              <a:gd name="connsiteX17" fmla="*/ 5568 w 747355"/>
              <a:gd name="connsiteY17" fmla="*/ 174212 h 280511"/>
              <a:gd name="connsiteX18" fmla="*/ 117773 w 747355"/>
              <a:gd name="connsiteY18" fmla="*/ 252829 h 280511"/>
              <a:gd name="connsiteX19" fmla="*/ 117773 w 747355"/>
              <a:gd name="connsiteY19" fmla="*/ 252829 h 280511"/>
              <a:gd name="connsiteX20" fmla="*/ 206355 w 747355"/>
              <a:gd name="connsiteY20" fmla="*/ 280511 h 280511"/>
              <a:gd name="connsiteX21" fmla="*/ 541000 w 747355"/>
              <a:gd name="connsiteY21" fmla="*/ 280511 h 280511"/>
              <a:gd name="connsiteX22" fmla="*/ 629583 w 747355"/>
              <a:gd name="connsiteY22" fmla="*/ 252829 h 280511"/>
              <a:gd name="connsiteX23" fmla="*/ 629583 w 747355"/>
              <a:gd name="connsiteY23" fmla="*/ 252829 h 280511"/>
              <a:gd name="connsiteX24" fmla="*/ 741787 w 747355"/>
              <a:gd name="connsiteY24" fmla="*/ 174212 h 280511"/>
              <a:gd name="connsiteX25" fmla="*/ 722102 w 747355"/>
              <a:gd name="connsiteY25" fmla="*/ 161663 h 28051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</a:cxnLst>
            <a:rect l="l" t="t" r="r" b="b"/>
            <a:pathLst>
              <a:path w="747355" h="280511">
                <a:moveTo>
                  <a:pt x="722102" y="161663"/>
                </a:moveTo>
                <a:cubicBezTo>
                  <a:pt x="627614" y="171629"/>
                  <a:pt x="471119" y="193774"/>
                  <a:pt x="414032" y="232160"/>
                </a:cubicBezTo>
                <a:cubicBezTo>
                  <a:pt x="413048" y="232529"/>
                  <a:pt x="413048" y="233267"/>
                  <a:pt x="412064" y="233636"/>
                </a:cubicBezTo>
                <a:lnTo>
                  <a:pt x="412064" y="158341"/>
                </a:lnTo>
                <a:cubicBezTo>
                  <a:pt x="723087" y="147268"/>
                  <a:pt x="557733" y="3691"/>
                  <a:pt x="557733" y="3691"/>
                </a:cubicBezTo>
                <a:cubicBezTo>
                  <a:pt x="549859" y="-1107"/>
                  <a:pt x="531158" y="-1107"/>
                  <a:pt x="524268" y="3691"/>
                </a:cubicBezTo>
                <a:lnTo>
                  <a:pt x="457339" y="46137"/>
                </a:lnTo>
                <a:lnTo>
                  <a:pt x="390410" y="3691"/>
                </a:lnTo>
                <a:cubicBezTo>
                  <a:pt x="386473" y="1107"/>
                  <a:pt x="379583" y="0"/>
                  <a:pt x="373678" y="0"/>
                </a:cubicBezTo>
                <a:cubicBezTo>
                  <a:pt x="367772" y="0"/>
                  <a:pt x="360883" y="1107"/>
                  <a:pt x="356946" y="3691"/>
                </a:cubicBezTo>
                <a:lnTo>
                  <a:pt x="290017" y="46137"/>
                </a:lnTo>
                <a:lnTo>
                  <a:pt x="223088" y="3691"/>
                </a:lnTo>
                <a:cubicBezTo>
                  <a:pt x="215214" y="-1107"/>
                  <a:pt x="196513" y="-1107"/>
                  <a:pt x="189623" y="3691"/>
                </a:cubicBezTo>
                <a:cubicBezTo>
                  <a:pt x="189623" y="3691"/>
                  <a:pt x="24269" y="147268"/>
                  <a:pt x="334308" y="158341"/>
                </a:cubicBezTo>
                <a:lnTo>
                  <a:pt x="334308" y="233267"/>
                </a:lnTo>
                <a:cubicBezTo>
                  <a:pt x="334308" y="232898"/>
                  <a:pt x="333324" y="232898"/>
                  <a:pt x="333324" y="232529"/>
                </a:cubicBezTo>
                <a:cubicBezTo>
                  <a:pt x="276237" y="193774"/>
                  <a:pt x="120726" y="171998"/>
                  <a:pt x="25253" y="162032"/>
                </a:cubicBezTo>
                <a:cubicBezTo>
                  <a:pt x="5568" y="159818"/>
                  <a:pt x="-8211" y="168676"/>
                  <a:pt x="5568" y="174212"/>
                </a:cubicBezTo>
                <a:cubicBezTo>
                  <a:pt x="46907" y="190452"/>
                  <a:pt x="98088" y="217027"/>
                  <a:pt x="117773" y="252829"/>
                </a:cubicBezTo>
                <a:cubicBezTo>
                  <a:pt x="117773" y="252829"/>
                  <a:pt x="117773" y="252829"/>
                  <a:pt x="117773" y="252829"/>
                </a:cubicBezTo>
                <a:cubicBezTo>
                  <a:pt x="124663" y="268331"/>
                  <a:pt x="163048" y="280511"/>
                  <a:pt x="206355" y="280511"/>
                </a:cubicBezTo>
                <a:lnTo>
                  <a:pt x="541000" y="280511"/>
                </a:lnTo>
                <a:cubicBezTo>
                  <a:pt x="584307" y="280511"/>
                  <a:pt x="622693" y="268331"/>
                  <a:pt x="629583" y="252829"/>
                </a:cubicBezTo>
                <a:cubicBezTo>
                  <a:pt x="629583" y="252829"/>
                  <a:pt x="629583" y="252829"/>
                  <a:pt x="629583" y="252829"/>
                </a:cubicBezTo>
                <a:cubicBezTo>
                  <a:pt x="649268" y="217027"/>
                  <a:pt x="700449" y="190452"/>
                  <a:pt x="741787" y="174212"/>
                </a:cubicBezTo>
                <a:cubicBezTo>
                  <a:pt x="755567" y="168307"/>
                  <a:pt x="741787" y="159818"/>
                  <a:pt x="722102" y="161663"/>
                </a:cubicBezTo>
                <a:close/>
              </a:path>
            </a:pathLst>
          </a:custGeom>
          <a:solidFill>
            <a:srgbClr val="000000"/>
          </a:solidFill>
          <a:ln w="9823" cap="flat">
            <a:noFill/>
            <a:prstDash val="solid"/>
            <a:miter/>
          </a:ln>
        </p:spPr>
        <p:txBody>
          <a:bodyPr rtlCol="0" anchor="ctr"/>
          <a:lstStyle/>
          <a:p>
            <a:endParaRPr lang="ja-JP" altLang="en-US"/>
          </a:p>
        </p:txBody>
      </p:sp>
      <p:sp>
        <p:nvSpPr>
          <p:cNvPr id="11" name="直角三角形 10">
            <a:extLst>
              <a:ext uri="{FF2B5EF4-FFF2-40B4-BE49-F238E27FC236}">
                <a16:creationId xmlns:a16="http://schemas.microsoft.com/office/drawing/2014/main" id="{1D298E97-DC39-5846-AA7C-FDD64FC21521}"/>
              </a:ext>
            </a:extLst>
          </p:cNvPr>
          <p:cNvSpPr/>
          <p:nvPr/>
        </p:nvSpPr>
        <p:spPr>
          <a:xfrm rot="20888603">
            <a:off x="8160637" y="5642006"/>
            <a:ext cx="304800" cy="633046"/>
          </a:xfrm>
          <a:prstGeom prst="rtTriangle">
            <a:avLst/>
          </a:prstGeom>
          <a:solidFill>
            <a:schemeClr val="bg1">
              <a:lumMod val="50000"/>
            </a:schemeClr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稲妻 11">
            <a:extLst>
              <a:ext uri="{FF2B5EF4-FFF2-40B4-BE49-F238E27FC236}">
                <a16:creationId xmlns:a16="http://schemas.microsoft.com/office/drawing/2014/main" id="{24827638-4636-224F-9284-51E8C06009AB}"/>
              </a:ext>
            </a:extLst>
          </p:cNvPr>
          <p:cNvSpPr/>
          <p:nvPr/>
        </p:nvSpPr>
        <p:spPr>
          <a:xfrm rot="20640608">
            <a:off x="1752541" y="4993270"/>
            <a:ext cx="304800" cy="633046"/>
          </a:xfrm>
          <a:prstGeom prst="lightningBolt">
            <a:avLst/>
          </a:prstGeom>
          <a:solidFill>
            <a:schemeClr val="bg1">
              <a:lumMod val="50000"/>
            </a:schemeClr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平行四辺形 12">
            <a:extLst>
              <a:ext uri="{FF2B5EF4-FFF2-40B4-BE49-F238E27FC236}">
                <a16:creationId xmlns:a16="http://schemas.microsoft.com/office/drawing/2014/main" id="{CB48F107-06B8-2F47-B742-E134D4D7084C}"/>
              </a:ext>
            </a:extLst>
          </p:cNvPr>
          <p:cNvSpPr/>
          <p:nvPr/>
        </p:nvSpPr>
        <p:spPr>
          <a:xfrm rot="16671259">
            <a:off x="8022575" y="5363901"/>
            <a:ext cx="926123" cy="351283"/>
          </a:xfrm>
          <a:prstGeom prst="parallelogram">
            <a:avLst>
              <a:gd name="adj" fmla="val 85070"/>
            </a:avLst>
          </a:prstGeom>
          <a:solidFill>
            <a:schemeClr val="bg1">
              <a:lumMod val="85000"/>
            </a:schemeClr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平行四辺形 13">
            <a:extLst>
              <a:ext uri="{FF2B5EF4-FFF2-40B4-BE49-F238E27FC236}">
                <a16:creationId xmlns:a16="http://schemas.microsoft.com/office/drawing/2014/main" id="{FAAA1C56-6ACB-2B45-8EB7-5DD0971751E1}"/>
              </a:ext>
            </a:extLst>
          </p:cNvPr>
          <p:cNvSpPr/>
          <p:nvPr/>
        </p:nvSpPr>
        <p:spPr>
          <a:xfrm rot="16671259">
            <a:off x="8189255" y="5282249"/>
            <a:ext cx="926123" cy="351283"/>
          </a:xfrm>
          <a:prstGeom prst="parallelogram">
            <a:avLst>
              <a:gd name="adj" fmla="val 85070"/>
            </a:avLst>
          </a:prstGeom>
          <a:solidFill>
            <a:schemeClr val="bg1">
              <a:lumMod val="85000"/>
            </a:schemeClr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平行四辺形 14">
            <a:extLst>
              <a:ext uri="{FF2B5EF4-FFF2-40B4-BE49-F238E27FC236}">
                <a16:creationId xmlns:a16="http://schemas.microsoft.com/office/drawing/2014/main" id="{37298446-8AB1-284D-8345-6CD56F36D412}"/>
              </a:ext>
            </a:extLst>
          </p:cNvPr>
          <p:cNvSpPr/>
          <p:nvPr/>
        </p:nvSpPr>
        <p:spPr>
          <a:xfrm rot="16671259">
            <a:off x="8337446" y="5215476"/>
            <a:ext cx="926123" cy="351283"/>
          </a:xfrm>
          <a:prstGeom prst="parallelogram">
            <a:avLst>
              <a:gd name="adj" fmla="val 85070"/>
            </a:avLst>
          </a:prstGeom>
          <a:solidFill>
            <a:schemeClr val="bg1">
              <a:lumMod val="85000"/>
            </a:schemeClr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平行四辺形 15">
            <a:extLst>
              <a:ext uri="{FF2B5EF4-FFF2-40B4-BE49-F238E27FC236}">
                <a16:creationId xmlns:a16="http://schemas.microsoft.com/office/drawing/2014/main" id="{E47EA508-1F5C-C146-B478-21569D4E73A7}"/>
              </a:ext>
            </a:extLst>
          </p:cNvPr>
          <p:cNvSpPr/>
          <p:nvPr/>
        </p:nvSpPr>
        <p:spPr>
          <a:xfrm rot="16671259">
            <a:off x="8485637" y="5161042"/>
            <a:ext cx="926123" cy="351283"/>
          </a:xfrm>
          <a:prstGeom prst="parallelogram">
            <a:avLst>
              <a:gd name="adj" fmla="val 85070"/>
            </a:avLst>
          </a:prstGeom>
          <a:solidFill>
            <a:schemeClr val="bg1">
              <a:lumMod val="85000"/>
            </a:schemeClr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平行四辺形 16">
            <a:extLst>
              <a:ext uri="{FF2B5EF4-FFF2-40B4-BE49-F238E27FC236}">
                <a16:creationId xmlns:a16="http://schemas.microsoft.com/office/drawing/2014/main" id="{81BBA48F-966A-7442-B854-69A578AB8244}"/>
              </a:ext>
            </a:extLst>
          </p:cNvPr>
          <p:cNvSpPr/>
          <p:nvPr/>
        </p:nvSpPr>
        <p:spPr>
          <a:xfrm>
            <a:off x="6515157" y="7948397"/>
            <a:ext cx="926123" cy="351283"/>
          </a:xfrm>
          <a:prstGeom prst="parallelogram">
            <a:avLst>
              <a:gd name="adj" fmla="val 85070"/>
            </a:avLst>
          </a:prstGeom>
          <a:solidFill>
            <a:schemeClr val="bg1">
              <a:lumMod val="85000"/>
            </a:schemeClr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平行四辺形 17">
            <a:extLst>
              <a:ext uri="{FF2B5EF4-FFF2-40B4-BE49-F238E27FC236}">
                <a16:creationId xmlns:a16="http://schemas.microsoft.com/office/drawing/2014/main" id="{9396AF39-924B-1C40-BDBE-544606771154}"/>
              </a:ext>
            </a:extLst>
          </p:cNvPr>
          <p:cNvSpPr/>
          <p:nvPr/>
        </p:nvSpPr>
        <p:spPr>
          <a:xfrm>
            <a:off x="6806952" y="7597114"/>
            <a:ext cx="926123" cy="351283"/>
          </a:xfrm>
          <a:prstGeom prst="parallelogram">
            <a:avLst>
              <a:gd name="adj" fmla="val 85070"/>
            </a:avLst>
          </a:prstGeom>
          <a:solidFill>
            <a:schemeClr val="bg1">
              <a:lumMod val="85000"/>
            </a:schemeClr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" name="平行四辺形 18">
            <a:extLst>
              <a:ext uri="{FF2B5EF4-FFF2-40B4-BE49-F238E27FC236}">
                <a16:creationId xmlns:a16="http://schemas.microsoft.com/office/drawing/2014/main" id="{DAD2225C-F255-D44C-895C-335DA7B57C22}"/>
              </a:ext>
            </a:extLst>
          </p:cNvPr>
          <p:cNvSpPr/>
          <p:nvPr/>
        </p:nvSpPr>
        <p:spPr>
          <a:xfrm>
            <a:off x="7098747" y="7245831"/>
            <a:ext cx="926123" cy="351283"/>
          </a:xfrm>
          <a:prstGeom prst="parallelogram">
            <a:avLst>
              <a:gd name="adj" fmla="val 85070"/>
            </a:avLst>
          </a:prstGeom>
          <a:solidFill>
            <a:schemeClr val="bg1">
              <a:lumMod val="85000"/>
            </a:schemeClr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平行四辺形 19">
            <a:extLst>
              <a:ext uri="{FF2B5EF4-FFF2-40B4-BE49-F238E27FC236}">
                <a16:creationId xmlns:a16="http://schemas.microsoft.com/office/drawing/2014/main" id="{4CA24E1C-62C8-2E46-A2A7-BB1F29F61472}"/>
              </a:ext>
            </a:extLst>
          </p:cNvPr>
          <p:cNvSpPr/>
          <p:nvPr/>
        </p:nvSpPr>
        <p:spPr>
          <a:xfrm>
            <a:off x="7408567" y="6894548"/>
            <a:ext cx="926123" cy="351283"/>
          </a:xfrm>
          <a:prstGeom prst="parallelogram">
            <a:avLst>
              <a:gd name="adj" fmla="val 85070"/>
            </a:avLst>
          </a:prstGeom>
          <a:solidFill>
            <a:schemeClr val="bg1">
              <a:lumMod val="85000"/>
            </a:schemeClr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フローチャート: せん孔テープ 20">
            <a:extLst>
              <a:ext uri="{FF2B5EF4-FFF2-40B4-BE49-F238E27FC236}">
                <a16:creationId xmlns:a16="http://schemas.microsoft.com/office/drawing/2014/main" id="{9DB53332-91CC-BC4F-9DE4-C6379913F91A}"/>
              </a:ext>
            </a:extLst>
          </p:cNvPr>
          <p:cNvSpPr/>
          <p:nvPr/>
        </p:nvSpPr>
        <p:spPr>
          <a:xfrm rot="12608732">
            <a:off x="5229907" y="4877347"/>
            <a:ext cx="634701" cy="526924"/>
          </a:xfrm>
          <a:prstGeom prst="flowChartPunchedTape">
            <a:avLst/>
          </a:prstGeom>
          <a:solidFill>
            <a:schemeClr val="bg1">
              <a:lumMod val="85000"/>
            </a:schemeClr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フローチャート: せん孔テープ 21">
            <a:extLst>
              <a:ext uri="{FF2B5EF4-FFF2-40B4-BE49-F238E27FC236}">
                <a16:creationId xmlns:a16="http://schemas.microsoft.com/office/drawing/2014/main" id="{88C529DC-33F8-8D43-9484-BF3948F4A129}"/>
              </a:ext>
            </a:extLst>
          </p:cNvPr>
          <p:cNvSpPr/>
          <p:nvPr/>
        </p:nvSpPr>
        <p:spPr>
          <a:xfrm rot="12608732">
            <a:off x="5425794" y="4772019"/>
            <a:ext cx="634701" cy="526924"/>
          </a:xfrm>
          <a:prstGeom prst="flowChartPunchedTape">
            <a:avLst/>
          </a:prstGeom>
          <a:solidFill>
            <a:schemeClr val="bg1">
              <a:lumMod val="85000"/>
            </a:schemeClr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フローチャート: せん孔テープ 22">
            <a:extLst>
              <a:ext uri="{FF2B5EF4-FFF2-40B4-BE49-F238E27FC236}">
                <a16:creationId xmlns:a16="http://schemas.microsoft.com/office/drawing/2014/main" id="{10EB89D9-26B8-7341-8C50-D68C5A0C0F98}"/>
              </a:ext>
            </a:extLst>
          </p:cNvPr>
          <p:cNvSpPr/>
          <p:nvPr/>
        </p:nvSpPr>
        <p:spPr>
          <a:xfrm rot="12608732">
            <a:off x="5636647" y="4615823"/>
            <a:ext cx="634701" cy="526924"/>
          </a:xfrm>
          <a:prstGeom prst="flowChartPunchedTape">
            <a:avLst/>
          </a:prstGeom>
          <a:solidFill>
            <a:schemeClr val="bg1">
              <a:lumMod val="85000"/>
            </a:schemeClr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A7164C0E-0584-4C41-A46E-06378ABA8730}"/>
              </a:ext>
            </a:extLst>
          </p:cNvPr>
          <p:cNvSpPr txBox="1"/>
          <p:nvPr/>
        </p:nvSpPr>
        <p:spPr>
          <a:xfrm>
            <a:off x="6467013" y="4014706"/>
            <a:ext cx="337949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Meiryo UI" panose="020B0604030504040204" pitchFamily="34" charset="-128"/>
                <a:ea typeface="Meiryo UI" panose="020B0604030504040204" pitchFamily="34" charset="-128"/>
              </a:rPr>
              <a:t>C    Array tomography</a:t>
            </a:r>
            <a:endParaRPr kumimoji="1" lang="ja-JP" altLang="en-US" sz="2000" b="1">
              <a:latin typeface="Meiryo UI" panose="020B0604030504040204" pitchFamily="34" charset="-128"/>
              <a:ea typeface="Meiryo UI" panose="020B0604030504040204" pitchFamily="34" charset="-128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E218D9D8-2F5C-F64F-9B03-25130C353CFC}"/>
              </a:ext>
            </a:extLst>
          </p:cNvPr>
          <p:cNvSpPr txBox="1"/>
          <p:nvPr/>
        </p:nvSpPr>
        <p:spPr>
          <a:xfrm>
            <a:off x="3336946" y="4014706"/>
            <a:ext cx="267302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Meiryo UI" panose="020B0604030504040204" pitchFamily="34" charset="-128"/>
                <a:ea typeface="Meiryo UI" panose="020B0604030504040204" pitchFamily="34" charset="-128"/>
              </a:rPr>
              <a:t>B</a:t>
            </a:r>
            <a:r>
              <a:rPr lang="en-US" altLang="ja-JP" sz="2000" b="1" dirty="0">
                <a:latin typeface="Meiryo UI" panose="020B0604030504040204" pitchFamily="34" charset="-128"/>
                <a:ea typeface="Meiryo UI" panose="020B0604030504040204" pitchFamily="34" charset="-128"/>
              </a:rPr>
              <a:t>        </a:t>
            </a:r>
            <a:r>
              <a:rPr kumimoji="1" lang="en-US" altLang="ja-JP" sz="2000" b="1" dirty="0">
                <a:latin typeface="Meiryo UI" panose="020B0604030504040204" pitchFamily="34" charset="-128"/>
                <a:ea typeface="Meiryo UI" panose="020B0604030504040204" pitchFamily="34" charset="-128"/>
              </a:rPr>
              <a:t> SBF-SEM</a:t>
            </a:r>
            <a:endParaRPr kumimoji="1" lang="ja-JP" altLang="en-US" sz="2000" b="1">
              <a:latin typeface="Meiryo UI" panose="020B0604030504040204" pitchFamily="34" charset="-128"/>
              <a:ea typeface="Meiryo UI" panose="020B0604030504040204" pitchFamily="34" charset="-128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BD22E2F1-7864-154E-88F8-FAEC1BCD3470}"/>
              </a:ext>
            </a:extLst>
          </p:cNvPr>
          <p:cNvSpPr txBox="1"/>
          <p:nvPr/>
        </p:nvSpPr>
        <p:spPr>
          <a:xfrm>
            <a:off x="873064" y="4014706"/>
            <a:ext cx="209489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Meiryo UI" panose="020B0604030504040204" pitchFamily="34" charset="-128"/>
                <a:ea typeface="Meiryo UI" panose="020B0604030504040204" pitchFamily="34" charset="-128"/>
              </a:rPr>
              <a:t>A</a:t>
            </a:r>
            <a:r>
              <a:rPr lang="en-US" altLang="ja-JP" sz="2000" b="1" dirty="0">
                <a:latin typeface="Meiryo UI" panose="020B0604030504040204" pitchFamily="34" charset="-128"/>
                <a:ea typeface="Meiryo UI" panose="020B0604030504040204" pitchFamily="34" charset="-128"/>
              </a:rPr>
              <a:t>   </a:t>
            </a:r>
            <a:r>
              <a:rPr kumimoji="1" lang="en-US" altLang="ja-JP" sz="2000" b="1" dirty="0">
                <a:latin typeface="Meiryo UI" panose="020B0604030504040204" pitchFamily="34" charset="-128"/>
                <a:ea typeface="Meiryo UI" panose="020B0604030504040204" pitchFamily="34" charset="-128"/>
              </a:rPr>
              <a:t> FIB-SEM</a:t>
            </a:r>
            <a:endParaRPr kumimoji="1" lang="ja-JP" altLang="en-US" sz="2000" b="1">
              <a:latin typeface="Meiryo UI" panose="020B0604030504040204" pitchFamily="34" charset="-128"/>
              <a:ea typeface="Meiryo UI" panose="020B0604030504040204" pitchFamily="34" charset="-128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28D46788-0F10-FF43-B961-189D69BBECD8}"/>
              </a:ext>
            </a:extLst>
          </p:cNvPr>
          <p:cNvSpPr txBox="1"/>
          <p:nvPr/>
        </p:nvSpPr>
        <p:spPr>
          <a:xfrm>
            <a:off x="3392013" y="4925806"/>
            <a:ext cx="27660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Meiryo UI" panose="020B0604030504040204" pitchFamily="34" charset="-128"/>
                <a:ea typeface="Meiryo UI" panose="020B0604030504040204" pitchFamily="34" charset="-128"/>
              </a:rPr>
              <a:t>Diamond knife</a:t>
            </a:r>
            <a:endParaRPr kumimoji="1" lang="ja-JP" altLang="en-US" sz="1600">
              <a:latin typeface="Meiryo UI" panose="020B0604030504040204" pitchFamily="34" charset="-128"/>
              <a:ea typeface="Meiryo UI" panose="020B0604030504040204" pitchFamily="34" charset="-128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A6DA653C-4ACA-C840-AFF3-444837CD38F4}"/>
              </a:ext>
            </a:extLst>
          </p:cNvPr>
          <p:cNvSpPr txBox="1"/>
          <p:nvPr/>
        </p:nvSpPr>
        <p:spPr>
          <a:xfrm>
            <a:off x="1051462" y="4663219"/>
            <a:ext cx="1934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Meiryo UI" panose="020B0604030504040204" pitchFamily="34" charset="-128"/>
                <a:ea typeface="Meiryo UI" panose="020B0604030504040204" pitchFamily="34" charset="-128"/>
              </a:rPr>
              <a:t>ion beam</a:t>
            </a:r>
            <a:endParaRPr kumimoji="1" lang="ja-JP" altLang="en-US" sz="1600">
              <a:latin typeface="Meiryo UI" panose="020B0604030504040204" pitchFamily="34" charset="-128"/>
              <a:ea typeface="Meiryo UI" panose="020B0604030504040204" pitchFamily="34" charset="-128"/>
            </a:endParaRPr>
          </a:p>
        </p:txBody>
      </p:sp>
      <p:sp>
        <p:nvSpPr>
          <p:cNvPr id="29" name="下矢印 28">
            <a:extLst>
              <a:ext uri="{FF2B5EF4-FFF2-40B4-BE49-F238E27FC236}">
                <a16:creationId xmlns:a16="http://schemas.microsoft.com/office/drawing/2014/main" id="{CC1A67D9-1173-7747-BFC6-1C0ECD851E76}"/>
              </a:ext>
            </a:extLst>
          </p:cNvPr>
          <p:cNvSpPr/>
          <p:nvPr/>
        </p:nvSpPr>
        <p:spPr>
          <a:xfrm>
            <a:off x="7590610" y="6387074"/>
            <a:ext cx="319448" cy="263769"/>
          </a:xfrm>
          <a:prstGeom prst="downArrow">
            <a:avLst/>
          </a:prstGeom>
          <a:solidFill>
            <a:schemeClr val="tx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B7476B26-543F-1045-B5D8-41A40F4E7CB5}"/>
              </a:ext>
            </a:extLst>
          </p:cNvPr>
          <p:cNvSpPr txBox="1"/>
          <p:nvPr/>
        </p:nvSpPr>
        <p:spPr>
          <a:xfrm>
            <a:off x="7820017" y="7610456"/>
            <a:ext cx="191837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Meiryo UI" panose="020B0604030504040204" pitchFamily="34" charset="-128"/>
                <a:ea typeface="Meiryo UI" panose="020B0604030504040204" pitchFamily="34" charset="-128"/>
              </a:rPr>
              <a:t>Placed on </a:t>
            </a:r>
          </a:p>
          <a:p>
            <a:r>
              <a:rPr kumimoji="1" lang="en-US" altLang="ja-JP" dirty="0">
                <a:latin typeface="Meiryo UI" panose="020B0604030504040204" pitchFamily="34" charset="-128"/>
                <a:ea typeface="Meiryo UI" panose="020B0604030504040204" pitchFamily="34" charset="-128"/>
              </a:rPr>
              <a:t>sample board</a:t>
            </a:r>
            <a:endParaRPr kumimoji="1" lang="ja-JP" altLang="en-US">
              <a:latin typeface="Meiryo UI" panose="020B0604030504040204" pitchFamily="34" charset="-128"/>
              <a:ea typeface="Meiryo UI" panose="020B0604030504040204" pitchFamily="34" charset="-128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F644D315-4BCB-5340-9591-681F6B01059D}"/>
              </a:ext>
            </a:extLst>
          </p:cNvPr>
          <p:cNvSpPr txBox="1"/>
          <p:nvPr/>
        </p:nvSpPr>
        <p:spPr>
          <a:xfrm>
            <a:off x="3507002" y="6894548"/>
            <a:ext cx="191837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Meiryo UI" panose="020B0604030504040204" pitchFamily="34" charset="-128"/>
                <a:ea typeface="Meiryo UI" panose="020B0604030504040204" pitchFamily="34" charset="-128"/>
              </a:rPr>
              <a:t>Discarded after observation</a:t>
            </a:r>
            <a:endParaRPr kumimoji="1" lang="ja-JP" altLang="en-US">
              <a:latin typeface="Meiryo UI" panose="020B0604030504040204" pitchFamily="34" charset="-128"/>
              <a:ea typeface="Meiryo UI" panose="020B0604030504040204" pitchFamily="34" charset="-128"/>
            </a:endParaRPr>
          </a:p>
        </p:txBody>
      </p: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id="{D671B568-CAA2-DE4C-AB17-82E6AA39C249}"/>
              </a:ext>
            </a:extLst>
          </p:cNvPr>
          <p:cNvCxnSpPr>
            <a:cxnSpLocks/>
          </p:cNvCxnSpPr>
          <p:nvPr/>
        </p:nvCxnSpPr>
        <p:spPr>
          <a:xfrm>
            <a:off x="3301761" y="5957845"/>
            <a:ext cx="410072" cy="83051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C4BACD4E-94F2-B144-9E10-B978CC4A3374}"/>
              </a:ext>
            </a:extLst>
          </p:cNvPr>
          <p:cNvCxnSpPr>
            <a:cxnSpLocks/>
          </p:cNvCxnSpPr>
          <p:nvPr/>
        </p:nvCxnSpPr>
        <p:spPr>
          <a:xfrm flipH="1">
            <a:off x="5322646" y="5275985"/>
            <a:ext cx="677592" cy="15123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星 12 33">
            <a:extLst>
              <a:ext uri="{FF2B5EF4-FFF2-40B4-BE49-F238E27FC236}">
                <a16:creationId xmlns:a16="http://schemas.microsoft.com/office/drawing/2014/main" id="{7668684A-4E44-5441-8CF3-E2D5F5D8BF7A}"/>
              </a:ext>
            </a:extLst>
          </p:cNvPr>
          <p:cNvSpPr/>
          <p:nvPr/>
        </p:nvSpPr>
        <p:spPr>
          <a:xfrm>
            <a:off x="2758422" y="5384852"/>
            <a:ext cx="376910" cy="374400"/>
          </a:xfrm>
          <a:prstGeom prst="star12">
            <a:avLst/>
          </a:prstGeom>
          <a:solidFill>
            <a:schemeClr val="bg1">
              <a:lumMod val="75000"/>
            </a:schemeClr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" name="星 12 34">
            <a:extLst>
              <a:ext uri="{FF2B5EF4-FFF2-40B4-BE49-F238E27FC236}">
                <a16:creationId xmlns:a16="http://schemas.microsoft.com/office/drawing/2014/main" id="{CBBD525F-D5E0-A843-9CE0-84860723DC49}"/>
              </a:ext>
            </a:extLst>
          </p:cNvPr>
          <p:cNvSpPr/>
          <p:nvPr/>
        </p:nvSpPr>
        <p:spPr>
          <a:xfrm>
            <a:off x="2926231" y="5607354"/>
            <a:ext cx="376910" cy="374400"/>
          </a:xfrm>
          <a:prstGeom prst="star12">
            <a:avLst/>
          </a:prstGeom>
          <a:solidFill>
            <a:schemeClr val="bg1">
              <a:lumMod val="75000"/>
            </a:schemeClr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" name="星 12 35">
            <a:extLst>
              <a:ext uri="{FF2B5EF4-FFF2-40B4-BE49-F238E27FC236}">
                <a16:creationId xmlns:a16="http://schemas.microsoft.com/office/drawing/2014/main" id="{AD69F5E8-93C5-DD47-8296-A904E736F3AB}"/>
              </a:ext>
            </a:extLst>
          </p:cNvPr>
          <p:cNvSpPr/>
          <p:nvPr/>
        </p:nvSpPr>
        <p:spPr>
          <a:xfrm>
            <a:off x="2967960" y="5309793"/>
            <a:ext cx="376910" cy="374400"/>
          </a:xfrm>
          <a:prstGeom prst="star12">
            <a:avLst/>
          </a:prstGeom>
          <a:solidFill>
            <a:schemeClr val="bg1">
              <a:lumMod val="75000"/>
            </a:schemeClr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" name="直角三角形 36">
            <a:extLst>
              <a:ext uri="{FF2B5EF4-FFF2-40B4-BE49-F238E27FC236}">
                <a16:creationId xmlns:a16="http://schemas.microsoft.com/office/drawing/2014/main" id="{F494E011-4DEB-4344-87EE-65C8A2E115A8}"/>
              </a:ext>
            </a:extLst>
          </p:cNvPr>
          <p:cNvSpPr/>
          <p:nvPr/>
        </p:nvSpPr>
        <p:spPr>
          <a:xfrm rot="16543394" flipV="1">
            <a:off x="4081245" y="5137590"/>
            <a:ext cx="304800" cy="633046"/>
          </a:xfrm>
          <a:prstGeom prst="rtTriangle">
            <a:avLst/>
          </a:prstGeom>
          <a:solidFill>
            <a:schemeClr val="bg1">
              <a:lumMod val="50000"/>
            </a:schemeClr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31CAE588-2927-B145-BFDA-528488C6C0BF}"/>
              </a:ext>
            </a:extLst>
          </p:cNvPr>
          <p:cNvSpPr txBox="1"/>
          <p:nvPr/>
        </p:nvSpPr>
        <p:spPr>
          <a:xfrm>
            <a:off x="0" y="0"/>
            <a:ext cx="6672148" cy="8617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0" dirty="0"/>
              <a:t>Supplementary Figure S2</a:t>
            </a:r>
            <a:endParaRPr kumimoji="1" lang="ja-JP" altLang="en-US" sz="5000"/>
          </a:p>
        </p:txBody>
      </p:sp>
    </p:spTree>
    <p:extLst>
      <p:ext uri="{BB962C8B-B14F-4D97-AF65-F5344CB8AC3E}">
        <p14:creationId xmlns:p14="http://schemas.microsoft.com/office/powerpoint/2010/main" val="34572486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11</TotalTime>
  <Words>47</Words>
  <Application>Microsoft Macintosh PowerPoint</Application>
  <PresentationFormat>ユーザー設定</PresentationFormat>
  <Paragraphs>24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9" baseType="lpstr">
      <vt:lpstr>Meiryo UI</vt:lpstr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UME SATOSHI</dc:creator>
  <cp:lastModifiedBy>Microsoft Office User</cp:lastModifiedBy>
  <cp:revision>99</cp:revision>
  <dcterms:created xsi:type="dcterms:W3CDTF">2021-10-15T10:20:25Z</dcterms:created>
  <dcterms:modified xsi:type="dcterms:W3CDTF">2023-03-04T14:29:55Z</dcterms:modified>
</cp:coreProperties>
</file>